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pptx" ContentType="application/vnd.openxmlformats-officedocument.presentationml.presentation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0"/>
  </p:notesMasterIdLst>
  <p:sldIdLst>
    <p:sldId id="256" r:id="rId2"/>
    <p:sldId id="366" r:id="rId3"/>
    <p:sldId id="273" r:id="rId4"/>
    <p:sldId id="367" r:id="rId5"/>
    <p:sldId id="365" r:id="rId6"/>
    <p:sldId id="277" r:id="rId7"/>
    <p:sldId id="284" r:id="rId8"/>
    <p:sldId id="362" r:id="rId9"/>
    <p:sldId id="283" r:id="rId10"/>
    <p:sldId id="285" r:id="rId11"/>
    <p:sldId id="363" r:id="rId12"/>
    <p:sldId id="368" r:id="rId13"/>
    <p:sldId id="327" r:id="rId14"/>
    <p:sldId id="369" r:id="rId15"/>
    <p:sldId id="281" r:id="rId16"/>
    <p:sldId id="282" r:id="rId17"/>
    <p:sldId id="386" r:id="rId18"/>
    <p:sldId id="264" r:id="rId19"/>
    <p:sldId id="265" r:id="rId20"/>
    <p:sldId id="266" r:id="rId21"/>
    <p:sldId id="267" r:id="rId22"/>
    <p:sldId id="360" r:id="rId23"/>
    <p:sldId id="371" r:id="rId24"/>
    <p:sldId id="379" r:id="rId25"/>
    <p:sldId id="385" r:id="rId26"/>
    <p:sldId id="384" r:id="rId27"/>
    <p:sldId id="370" r:id="rId28"/>
    <p:sldId id="378" r:id="rId29"/>
    <p:sldId id="376" r:id="rId30"/>
    <p:sldId id="372" r:id="rId31"/>
    <p:sldId id="268" r:id="rId32"/>
    <p:sldId id="373" r:id="rId33"/>
    <p:sldId id="357" r:id="rId34"/>
    <p:sldId id="358" r:id="rId35"/>
    <p:sldId id="380" r:id="rId36"/>
    <p:sldId id="377" r:id="rId37"/>
    <p:sldId id="381" r:id="rId38"/>
    <p:sldId id="359" r:id="rId3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280" autoAdjust="0"/>
  </p:normalViewPr>
  <p:slideViewPr>
    <p:cSldViewPr>
      <p:cViewPr varScale="1">
        <p:scale>
          <a:sx n="101" d="100"/>
          <a:sy n="101" d="100"/>
        </p:scale>
        <p:origin x="191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08T15:01:06.115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595 122 24575,'-245'13'0,"51"-2"0,-12-11 0,-85 4 0,128 20 0,146-21 0,0 0 0,0 0 0,1 2 0,-1 0 0,1 0 0,-23 13 0,20-9 0,-1-1 0,0-1 0,-38 8 0,31-11 0,9-2 0,1 1 0,-1 1 0,1 0 0,-32 13 0,44-14 0,-1 0 0,1 0 0,0 1 0,0-1 0,0 1 0,1 0 0,-1 1 0,1-1 0,0 1 0,0 0 0,1 0 0,-1 0 0,1 0 0,0 1 0,1-1 0,-1 1 0,1 0 0,-2 7 0,-1 11 0,0-1 0,2 1 0,0 0 0,1 27 0,8 100 0,-5-135 0,0-4 0,1 0 0,0 0 0,0 0 0,2-1 0,-1 1 0,1-1 0,1 0 0,0 0 0,0-1 0,1 1 0,1-1 0,-1 0 0,2-1 0,-1 0 0,1 0 0,1 0 0,0-1 0,0-1 0,0 1 0,1-1 0,0-1 0,0 0 0,1 0 0,0-1 0,17 5 0,119 36 0,282 49 0,156-19 0,-341-49 0,-97-6 0,-60-8 0,146 5 0,-80-14 0,-1 7 0,182 36 0,-188-26 0,195 4 0,150-26 0,-216-3 0,1438 4 0,-1356-27 0,-88 3 0,-226 19 0,-1-1 0,73-20 0,-66 13 0,71-9 0,485 10 0,-356 15 0,926-3 0,-1145-2 0,1-1 0,-1-2 0,0-1 0,40-13 0,56-12 0,240-40 0,-342 65 0,-1 0 0,0-1 0,37-17 0,-53 21 0,-1 0 0,1-1 0,-1 0 0,0 0 0,-1 0 0,1 0 0,-1-1 0,0 0 0,0 0 0,0-1 0,-1 1 0,0-1 0,0 0 0,0 0 0,0 0 0,4-13 0,-5 7 0,0-1 0,-1 1 0,0-1 0,-1 0 0,-1 1 0,0-1 0,0 0 0,-1 1 0,-1-1 0,0 1 0,-1-1 0,0 1 0,-1 0 0,-7-15 0,-5-5 0,-2 0 0,-1 1 0,-39-48 0,31 44 0,9 10 0,0 1 0,-2 1 0,0 1 0,-37-31 0,32 33 0,0 2 0,-1 0 0,-1 2 0,0 0 0,-1 2 0,-1 2 0,-57-18 0,-40-3 0,-2 7 0,-2 4 0,-210-6 0,-2016 27 0,1025 3 0,1219-7 0,-117-20 0,30 1 0,-382-2 0,-1092 27 0,1655-2 0,0-1 0,0-1 0,0 0 0,-30-11 0,-20-3 0,66 16-76,-1 0 1,1 1-1,-1 0 0,0 0 0,1 0 0,-1 0 0,0 0 0,1 0 1,-1 1-1,1-1 0,-1 1 0,1 0 0,-1-1 0,1 1 1,-1 0-1,1 1 0,-3 1 0,-13 12-675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08T15:01:31.39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12 107 24575,'-13'198'0,"-1"4"0,14-156 0,1 26 0,-3-1 0,-12 78 0,-2 3 0,5-35 0,2-35 0,-9 54 0,10-78 0,3 0 0,2 0 0,6 73 0,0-14 0,-5 5 0,5 131 0,3-198 0,19 71 0,-12-67 0,15 32 0,-20-72 0,-2 1 0,0-1 0,-1 1 0,4 35 0,-5 22 0,8 83 0,-4-89 0,-2 1 0,-4 0 0,-9 89 0,-5-65 0,5-50 0,-1 58 0,8-30 0,1 10 0,-17 130 0,10-149 0,3 126 0,1-8 0,0-168 0,0 0 0,-2 0 0,0-1 0,-10 25 0,8-25 0,1 1 0,1 0 0,0 0 0,-3 24 0,2 67 0,11 127 0,-5-220 0,1 0 0,0-1 0,1 1 0,0-1 0,1 1 0,0-1 0,1 0 0,13 22 0,-15-28 0,0-1 0,1 0 0,0 0 0,1 0 0,-1 0 0,1-1 0,0 1 0,0-1 0,0 0 0,0-1 0,1 1 0,0-1 0,-1 0 0,1-1 0,0 1 0,1-1 0,-1 0 0,0-1 0,9 2 0,133 0 0,12 0 0,129 35 0,-105-11 0,330 5 0,-453-32 0,86-6 0,-129 4 0,0-1 0,-1 0 0,1-1 0,-1-1 0,33-15 0,-21 10 0,1 0 0,0 2 0,0 0 0,0 3 0,1 0 0,34 1 0,-9-2 0,441-5 0,-298 14 0,5497-3 0,-5643 2 0,56 11 0,-11-2 0,116 13 0,-91-9 0,124 0 0,3897-18 251,-2155 5-6155,-1288-30-1077,-315 8 8780,5 13 8770,-210-5-10282,-16-1-308,689 14 21,-828 1 0,0 1 0,0 0 0,0 3 0,25 7 0,-23-5 0,1-1 0,57 5 0,55-9 0,-67-4 0,98 14 0,-130-8 0,-12-1 0,0 1 0,46 13 0,-64-14 0,3 2 0,0-1 0,1-1 0,-1 0 0,1-1 0,18 0 0,-31-2 0,0-1 0,0 0 0,0-1 0,0 1 0,0-1 0,0 1 0,0-1 0,1 0 0,-2 0 0,1 0 0,0 0 0,0-1 0,0 1 0,0-1 0,-1 0 0,1 1 0,-1-1 0,1-1 0,-1 1 0,0 0 0,0 0 0,0-1 0,0 1 0,0-1 0,-1 0 0,1 1 0,-1-1 0,0 0 0,0 0 0,0 0 0,2-6 0,-2 0 0,1 0 0,-1-1 0,0 1 0,-1 0 0,0-1 0,-1 1 0,0 0 0,-3-12 0,-24-75 0,7 26 0,10 18 0,2-1 0,-3-89 0,13-111 0,1 119 0,1-14 0,38-245 0,-11 197 0,6-206 0,-10 47 0,0-41 0,-25 355 0,-3-285 0,-2 250 0,-4 0 0,-22-93 0,9 88 0,-52-126 0,-50-66 0,-13-29 0,120 268 0,0 1 0,-25-33 0,25 40 0,0 0 0,2 0 0,-21-57 0,14 27 0,-2 0 0,-37-65 0,56 115 0,0 0 0,0 0 0,0 1 0,-1-1 0,0 1 0,0 0 0,-1 1 0,1-1 0,-1 1 0,0 0 0,0 0 0,0 1 0,-1-1 0,1 1 0,-1 1 0,0 0 0,1-1 0,-1 2 0,-14-3 0,-10 2 0,0 0 0,-1 2 0,-43 5 0,1 0 0,-1483-2 0,792-6 0,764 3 0,-50-1 0,-1 2 0,1 2 0,-99 20 0,91-7 0,-1-3 0,0-2 0,-90 4 0,103-12 0,-89 19 0,83-11 0,-54 3 0,-316-10 0,223-7 0,105 2 0,-109-14 0,118 5 0,38 5 0,-1-1 0,1-3 0,-73-22 0,80 17 0,0 2 0,-1 2 0,0 2 0,0 2 0,-1 1 0,-51 1 0,-72-9 0,54 1 0,82 9 0,2-2 0,-32-9 0,-38-7 0,-35 11 0,-191 9 0,143 4 0,-3625-3 0,3509 26 0,39 0 0,-632-22 0,466-7 0,-3552 3 0,3944-2 0,0-1 0,0-2 0,-44-12 0,42 8 0,0 2 0,-62-5 0,-88-3 0,98 6 0,11 1 0,-243-12 0,-795 21 0,1051 1-455,0 2 0,-103 21 0,136-18-6371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08T15:01:34.789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677 5 24575,'-66'-1'0,"1"3"0,-1 3 0,-99 20 0,147-21 0,-26 6 0,-63 23 0,94-27 0,1-1 0,-1 1 0,1 1 0,0 0 0,1 1 0,-1 1 0,2-1 0,-1 2 0,-11 13 0,20-21 0,0 1 0,0 0 0,0 0 0,1 0 0,-1 0 0,1 0 0,0 0 0,0 0 0,0 0 0,0 0 0,0 1 0,1-1 0,-1 0 0,1 1 0,0-1 0,1 5 0,-1-1 0,2 0 0,-1 0 0,1 0 0,0 1 0,1-2 0,0 1 0,4 7 0,1 2 0,2-1 0,0-1 0,1 0 0,0 0 0,21 18 0,9 3 0,2-1 0,1-3 0,1-2 0,2-1 0,1-3 0,71 28 0,-79-36 0,-1-2 0,2-1 0,0-3 0,0-1 0,1-1 0,62 3 0,107 1 0,21 1 0,-201-15 0,-1-1 0,1-1 0,-1-2 0,0-1 0,0-2 0,56-21 0,15-30 0,-92 54 0,0 0 0,0-1 0,-1 0 0,0 0 0,0 0 0,-1-1 0,1-1 0,-1 1 0,-1-1 0,0 0 0,0 0 0,0-1 0,-1 0 0,0 0 0,5-15 0,-3 3 0,-2-1 0,0 0 0,-1 0 0,-1 0 0,-1 0 0,-1-27 0,-1 21 0,1 3 0,-1 1 0,-2-1 0,0 0 0,-7-30 0,7 49 0,0-1 0,0 1 0,0 0 0,-1 0 0,0 0 0,0 0 0,0 1 0,-1-1 0,0 1 0,0 0 0,0 0 0,-1 0 0,0 1 0,0-1 0,0 1 0,0 0 0,-1 1 0,1-1 0,-1 1 0,-12-5 0,-5 1 0,0 0 0,-1 2 0,0 0 0,-48-2 0,-102 8 0,70 2 0,-255-3-1365,330 0-5461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08T15:01:39.944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350 0 24575,'0'6'0,"-1"-1"0,0 0 0,0 1 0,0-1 0,0 0 0,-1 1 0,0-1 0,0 0 0,0 0 0,-1 0 0,0-1 0,0 1 0,0-1 0,0 1 0,-1-1 0,0 0 0,-5 4 0,-8 7 0,-1-2 0,0 0 0,-21 10 0,13-7 0,17-11 0,-14 8 0,1 2 0,0 0 0,-24 24 0,40-33 0,0 0 0,0 1 0,1 0 0,0 0 0,0 0 0,1 0 0,0 1 0,0 0 0,1 0 0,0 0 0,0 0 0,1 1 0,0-1 0,-1 11 0,1-3 0,1 0 0,0 0 0,1 0 0,1 0 0,3 21 0,-3-33 0,0 1 0,0-1 0,1 0 0,-1 0 0,1 0 0,0 0 0,0 0 0,0-1 0,0 1 0,1 0 0,0-1 0,-1 0 0,1 0 0,1 0 0,-1 0 0,0 0 0,1 0 0,-1-1 0,1 0 0,0 0 0,0 0 0,-1 0 0,2 0 0,5 1 0,16 2 0,0-2 0,1 0 0,-1-2 0,0 0 0,39-6 0,-35 3 0,-1 1 0,1 1 0,0 1 0,30 5 0,111 23 0,0-7 0,313-3 0,-446-18 0,-25 0 0,0 0 0,0-2 0,0 1 0,-1-1 0,18-5 0,-26 5 0,0 0 0,-1-1 0,1 1 0,-1-1 0,1 0 0,-1 0 0,0 0 0,0-1 0,0 1 0,0-1 0,0 0 0,0 1 0,-1-1 0,1-1 0,-1 1 0,0 0 0,0-1 0,0 1 0,0-1 0,-1 1 0,3-8 0,1-10 0,-1 0 0,-1-1 0,-1 1 0,-1-1 0,-1 0 0,0 1 0,-2-1 0,-1 1 0,0-1 0,-2 1 0,0 0 0,-1 1 0,-1-1 0,-2 1 0,-17-33 0,23 48 0,-1-1 0,0 1 0,0 0 0,-1 0 0,1 0 0,-1 1 0,0-1 0,0 1 0,-1 0 0,1 1 0,-1-1 0,0 1 0,-11-4 0,-7-1 0,0 0 0,-35-5 0,-16-5 0,27 5 0,-1 2 0,-96-8 0,78 11 0,-163-14 0,171 16-682,-87 1-1,116 5-6143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08T15:02:26.220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0 24575,'0'0'-819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5390B1-BB53-4EA0-8E1B-2EBC0DC5B0C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F15276-3F30-40FA-A6E6-3845F3F254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691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derstand the consequences of an incorrect </a:t>
            </a:r>
            <a:r>
              <a:rPr lang="en-GB" sz="12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nA</a:t>
            </a: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926481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Need to say it's in the hospital PADL guidelines if you want a proper look at i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1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062340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Allergy phenotypes eligible for de-label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1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922741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2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029109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Understand the risk of future reactions in low-risk patients.</a:t>
            </a:r>
          </a:p>
          <a:p>
            <a:r>
              <a:rPr lang="en-GB" dirty="0"/>
              <a:t>DOI: 10.1080/14787210.2019.1617132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3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600108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Understand that PADL is done within a governance framework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3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31406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F4D59A2-9C61-4BB6-9273-892397A1F39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877253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F4D59A2-9C61-4BB6-9273-892397A1F39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127086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F4D59A2-9C61-4BB6-9273-892397A1F39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0739705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F4D59A2-9C61-4BB6-9273-892397A1F39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1356767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F4D59A2-9C61-4BB6-9273-892397A1F39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033621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F4D59A2-9C61-4BB6-9273-892397A1F39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4029896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Understand the requirements of a </a:t>
            </a:r>
            <a:r>
              <a:rPr lang="en-GB" dirty="0" err="1"/>
              <a:t>penA</a:t>
            </a:r>
            <a:r>
              <a:rPr lang="en-GB" dirty="0"/>
              <a:t> focused history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97174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Understand how to risk assess </a:t>
            </a:r>
            <a:r>
              <a:rPr lang="en-GB" dirty="0" err="1"/>
              <a:t>penA</a:t>
            </a:r>
            <a:r>
              <a:rPr lang="en-GB" dirty="0"/>
              <a:t> histories using a decision support too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15276-3F30-40FA-A6E6-3845F3F254F0}" type="slidenum">
              <a:rPr lang="en-GB" smtClean="0"/>
              <a:t>1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9694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5F030-F41C-480E-90FA-AAB83DCBB954}" type="datetime1">
              <a:rPr lang="en-US" smtClean="0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A3BD-FDAD-4699-A7FA-409933FAA183}" type="datetime1">
              <a:rPr lang="en-US" smtClean="0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60228-6CA1-47BF-AF1F-100B9357149C}" type="datetime1">
              <a:rPr lang="en-US" smtClean="0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96DB9-BAD0-483D-915D-CCA738D9CBA2}" type="datetime1">
              <a:rPr lang="en-US" smtClean="0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FE3C0-656D-4553-9D2B-4789D4E83FCB}" type="datetime1">
              <a:rPr lang="en-US" smtClean="0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D6530-225B-4D52-AC8D-6ACC42C089AE}" type="datetime1">
              <a:rPr lang="en-US" smtClean="0"/>
              <a:t>12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5DAA4-666D-408F-9815-9F0FD24463F2}" type="datetime1">
              <a:rPr lang="en-US" smtClean="0"/>
              <a:t>12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D4E9-D742-401C-BC34-2676DEBE6C43}" type="datetime1">
              <a:rPr lang="en-US" smtClean="0"/>
              <a:t>12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6DA7C-B4A9-42FA-B5DE-E29AD9ED518E}" type="datetime1">
              <a:rPr lang="en-US" smtClean="0"/>
              <a:t>12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DF85A-791B-4463-9377-151EF3D50F10}" type="datetime1">
              <a:rPr lang="en-US" smtClean="0"/>
              <a:t>12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81C15-1369-4CE3-8B1D-9E6392C47A88}" type="datetime1">
              <a:rPr lang="en-US" smtClean="0"/>
              <a:t>12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A0C84-042C-4097-96F6-A6F0107DBF0F}" type="datetime1">
              <a:rPr lang="en-US" smtClean="0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PowerPoint_Presentation.pptx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em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customXml" Target="../ink/ink1.xml"/><Relationship Id="rId7" Type="http://schemas.openxmlformats.org/officeDocument/2006/relationships/customXml" Target="../ink/ink3.xml"/><Relationship Id="rId12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0.png"/><Relationship Id="rId11" Type="http://schemas.openxmlformats.org/officeDocument/2006/relationships/customXml" Target="../ink/ink5.xml"/><Relationship Id="rId5" Type="http://schemas.openxmlformats.org/officeDocument/2006/relationships/customXml" Target="../ink/ink2.xml"/><Relationship Id="rId10" Type="http://schemas.openxmlformats.org/officeDocument/2006/relationships/image" Target="../media/image18.png"/><Relationship Id="rId4" Type="http://schemas.openxmlformats.org/officeDocument/2006/relationships/image" Target="../media/image15.png"/><Relationship Id="rId9" Type="http://schemas.openxmlformats.org/officeDocument/2006/relationships/customXml" Target="../ink/ink4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hyperlink" Target="http://dx.doi.org/10.1016/S0140-6736(18)32218-9" TargetMode="External"/><Relationship Id="rId2" Type="http://schemas.openxmlformats.org/officeDocument/2006/relationships/hyperlink" Target="https://www.futurelearn.com/courses/understanding-penicillin-allergy-assessment-and-delabelling" TargetMode="Externa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Penicillin allergy assessment and de-label competency-based training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2743200"/>
          </a:xfrm>
        </p:spPr>
        <p:txBody>
          <a:bodyPr>
            <a:normAutofit/>
          </a:bodyPr>
          <a:lstStyle/>
          <a:p>
            <a:r>
              <a:rPr lang="en-GB" dirty="0"/>
              <a:t>Neil Powell</a:t>
            </a:r>
          </a:p>
          <a:p>
            <a:pPr algn="l"/>
            <a:r>
              <a:rPr lang="en-GB" dirty="0"/>
              <a:t>Consultant Antimicrobial Pharmacist</a:t>
            </a:r>
          </a:p>
          <a:p>
            <a:pPr algn="l"/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61A5C0-18BE-5709-98D4-3F09B0D1F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3867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12528"/>
    </mc:Choice>
    <mc:Fallback xmlns="">
      <p:transition spd="slow" advTm="12528"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157E28-272E-4879-9579-FD6532706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9029"/>
            <a:ext cx="9144000" cy="1143000"/>
          </a:xfrm>
        </p:spPr>
        <p:txBody>
          <a:bodyPr>
            <a:noAutofit/>
          </a:bodyPr>
          <a:lstStyle/>
          <a:p>
            <a:r>
              <a:rPr lang="en-GB" sz="3200" b="1" dirty="0">
                <a:solidFill>
                  <a:prstClr val="black"/>
                </a:solidFill>
                <a:latin typeface="Calibri Light" panose="020F0302020204030204"/>
              </a:rPr>
              <a:t>Non-immediate reactions with systemic involvement</a:t>
            </a:r>
            <a:br>
              <a:rPr lang="en-GB" sz="3200" b="1" dirty="0">
                <a:solidFill>
                  <a:prstClr val="black"/>
                </a:solidFill>
                <a:latin typeface="Calibri Light" panose="020F0302020204030204"/>
              </a:rPr>
            </a:br>
            <a:r>
              <a:rPr lang="en-GB" sz="2400" b="1" dirty="0">
                <a:solidFill>
                  <a:prstClr val="black"/>
                </a:solidFill>
                <a:latin typeface="Calibri Light" panose="020F0302020204030204"/>
              </a:rPr>
              <a:t>(also called </a:t>
            </a:r>
            <a:r>
              <a:rPr lang="en-GB" sz="2400" b="1" dirty="0" err="1">
                <a:solidFill>
                  <a:prstClr val="black"/>
                </a:solidFill>
                <a:latin typeface="Calibri Light" panose="020F0302020204030204"/>
              </a:rPr>
              <a:t>Gell</a:t>
            </a:r>
            <a:r>
              <a:rPr lang="en-GB" sz="2400" b="1" dirty="0">
                <a:solidFill>
                  <a:prstClr val="black"/>
                </a:solidFill>
                <a:latin typeface="Calibri Light" panose="020F0302020204030204"/>
              </a:rPr>
              <a:t> &amp; Coombs types 2 &amp; 3) </a:t>
            </a:r>
            <a:endParaRPr lang="en-GB" sz="2400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C6DB14-4EEE-4588-AE77-38988DD508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501208"/>
            <a:ext cx="8229600" cy="4525963"/>
          </a:xfrm>
        </p:spPr>
        <p:txBody>
          <a:bodyPr>
            <a:normAutofit fontScale="85000" lnSpcReduction="10000"/>
          </a:bodyPr>
          <a:lstStyle/>
          <a:p>
            <a:r>
              <a:rPr lang="en-GB" u="sng" dirty="0"/>
              <a:t>Drug induced liver toxicity (DILI)</a:t>
            </a:r>
            <a:r>
              <a:rPr lang="en-GB" dirty="0"/>
              <a:t> - hepatitis is the main presentation, but some cases are accompanied by </a:t>
            </a:r>
            <a:r>
              <a:rPr lang="en-GB" u="sng" dirty="0"/>
              <a:t>rash</a:t>
            </a:r>
            <a:r>
              <a:rPr lang="en-GB" dirty="0"/>
              <a:t>, </a:t>
            </a:r>
            <a:r>
              <a:rPr lang="en-GB" u="sng" dirty="0"/>
              <a:t>fever</a:t>
            </a:r>
            <a:r>
              <a:rPr lang="en-GB" dirty="0"/>
              <a:t>, or </a:t>
            </a:r>
            <a:r>
              <a:rPr lang="en-GB" u="sng" dirty="0"/>
              <a:t>eosinophilia</a:t>
            </a:r>
            <a:r>
              <a:rPr lang="en-GB" dirty="0"/>
              <a:t>. Typical onset &gt;4 weeks post drug exposure. </a:t>
            </a:r>
          </a:p>
          <a:p>
            <a:r>
              <a:rPr lang="en-GB" u="sng" dirty="0"/>
              <a:t>Nephrotoxic (AIN) </a:t>
            </a:r>
            <a:r>
              <a:rPr lang="en-GB" dirty="0"/>
              <a:t>- </a:t>
            </a:r>
            <a:r>
              <a:rPr lang="en-GB" u="sng" dirty="0"/>
              <a:t>Rash</a:t>
            </a:r>
            <a:r>
              <a:rPr lang="en-GB" dirty="0"/>
              <a:t>, </a:t>
            </a:r>
            <a:r>
              <a:rPr lang="en-GB" u="sng" dirty="0"/>
              <a:t>acute kidney injury</a:t>
            </a:r>
            <a:r>
              <a:rPr lang="en-GB" dirty="0"/>
              <a:t>, white cell casts in urinary sediment, peripheral blood </a:t>
            </a:r>
            <a:r>
              <a:rPr lang="en-GB" u="sng" dirty="0"/>
              <a:t>eosinophilia</a:t>
            </a:r>
            <a:r>
              <a:rPr lang="en-GB" dirty="0"/>
              <a:t>, or </a:t>
            </a:r>
            <a:r>
              <a:rPr lang="en-GB" dirty="0" err="1"/>
              <a:t>eosinophiluria</a:t>
            </a:r>
            <a:r>
              <a:rPr lang="en-GB" dirty="0"/>
              <a:t>. Onset 3 days to 4 weeks post drug exposure.</a:t>
            </a:r>
            <a:endParaRPr lang="en-GB" dirty="0">
              <a:highlight>
                <a:srgbClr val="00FFFF"/>
              </a:highlight>
            </a:endParaRPr>
          </a:p>
          <a:p>
            <a:pPr>
              <a:defRPr/>
            </a:pPr>
            <a:r>
              <a:rPr lang="en-GB" u="sng" dirty="0"/>
              <a:t>Cytopenia </a:t>
            </a:r>
            <a:r>
              <a:rPr lang="en-GB" dirty="0"/>
              <a:t>– Haemolytic anaemia, thrombocytopenia, or vasculitis. Often &lt;72 h after drug exposure but can present up to day 15 post exposure</a:t>
            </a:r>
            <a:r>
              <a:rPr lang="en-GB" dirty="0">
                <a:solidFill>
                  <a:prstClr val="black"/>
                </a:solidFill>
                <a:latin typeface="Calibri" panose="020F0502020204030204"/>
              </a:rPr>
              <a:t>. </a:t>
            </a:r>
            <a:endParaRPr lang="en-GB" dirty="0">
              <a:solidFill>
                <a:prstClr val="black"/>
              </a:solidFill>
              <a:highlight>
                <a:srgbClr val="00FFFF"/>
              </a:highlight>
              <a:latin typeface="Calibri" panose="020F0502020204030204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B3B570-E5F5-903E-47CC-120461C64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1696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E4755-F44A-49F8-81B8-8C4D0758E6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8600" y="132853"/>
            <a:ext cx="8763000" cy="994172"/>
          </a:xfrm>
        </p:spPr>
        <p:txBody>
          <a:bodyPr>
            <a:normAutofit/>
          </a:bodyPr>
          <a:lstStyle/>
          <a:p>
            <a:r>
              <a:rPr lang="en-GB" sz="2800" b="1" dirty="0"/>
              <a:t>Non-immediate reactions without systemic involvement</a:t>
            </a:r>
            <a:br>
              <a:rPr lang="en-GB" sz="2800" b="1" dirty="0"/>
            </a:br>
            <a:r>
              <a:rPr lang="en-GB" sz="2800" b="1" dirty="0"/>
              <a:t>(also called </a:t>
            </a:r>
            <a:r>
              <a:rPr lang="en-GB" sz="2800" b="1" dirty="0" err="1"/>
              <a:t>Gell</a:t>
            </a:r>
            <a:r>
              <a:rPr lang="en-GB" sz="2800" b="1" dirty="0"/>
              <a:t> &amp; Coombs type 4)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9E01F8-A596-48EE-88ED-481D8CDB4F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2226468"/>
            <a:ext cx="5010149" cy="4098131"/>
          </a:xfrm>
        </p:spPr>
        <p:txBody>
          <a:bodyPr>
            <a:normAutofit/>
          </a:bodyPr>
          <a:lstStyle/>
          <a:p>
            <a:r>
              <a:rPr lang="en-GB" sz="3000" dirty="0"/>
              <a:t>Widespread red macules or papules (exanthema-like)</a:t>
            </a:r>
          </a:p>
          <a:p>
            <a:r>
              <a:rPr lang="en-GB" sz="3000" dirty="0"/>
              <a:t>Onset usually 6–10 days after first drug exposure or within 3 days of second exposure</a:t>
            </a:r>
          </a:p>
          <a:p>
            <a:endParaRPr lang="en-GB" dirty="0"/>
          </a:p>
          <a:p>
            <a:endParaRPr lang="en-GB" dirty="0"/>
          </a:p>
        </p:txBody>
      </p:sp>
      <p:pic>
        <p:nvPicPr>
          <p:cNvPr id="2050" name="Picture 2" descr="Exanthem">
            <a:extLst>
              <a:ext uri="{FF2B5EF4-FFF2-40B4-BE49-F238E27FC236}">
                <a16:creationId xmlns:a16="http://schemas.microsoft.com/office/drawing/2014/main" id="{BDA8D6ED-47DB-4407-B2A8-72A7BF332D1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9" r="5232" b="-1"/>
          <a:stretch/>
        </p:blipFill>
        <p:spPr bwMode="auto">
          <a:xfrm>
            <a:off x="5399470" y="1371600"/>
            <a:ext cx="3744530" cy="3200400"/>
          </a:xfrm>
          <a:custGeom>
            <a:avLst/>
            <a:gdLst/>
            <a:ahLst/>
            <a:cxnLst/>
            <a:rect l="l" t="t" r="r" b="b"/>
            <a:pathLst>
              <a:path w="3519312" h="3007909">
                <a:moveTo>
                  <a:pt x="519780" y="0"/>
                </a:moveTo>
                <a:lnTo>
                  <a:pt x="2999532" y="0"/>
                </a:lnTo>
                <a:lnTo>
                  <a:pt x="3003921" y="3989"/>
                </a:lnTo>
                <a:cubicBezTo>
                  <a:pt x="3322356" y="322424"/>
                  <a:pt x="3519312" y="762338"/>
                  <a:pt x="3519312" y="1248253"/>
                </a:cubicBezTo>
                <a:cubicBezTo>
                  <a:pt x="3519312" y="2220084"/>
                  <a:pt x="2731487" y="3007909"/>
                  <a:pt x="1759656" y="3007909"/>
                </a:cubicBezTo>
                <a:cubicBezTo>
                  <a:pt x="787826" y="3007909"/>
                  <a:pt x="0" y="2220084"/>
                  <a:pt x="0" y="1248253"/>
                </a:cubicBezTo>
                <a:cubicBezTo>
                  <a:pt x="0" y="762338"/>
                  <a:pt x="196957" y="322424"/>
                  <a:pt x="515392" y="3989"/>
                </a:cubicBez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561E6B6-B5AF-4F86-9574-493FEEFB7D7C}"/>
              </a:ext>
            </a:extLst>
          </p:cNvPr>
          <p:cNvSpPr txBox="1"/>
          <p:nvPr/>
        </p:nvSpPr>
        <p:spPr>
          <a:xfrm>
            <a:off x="7915666" y="5730490"/>
            <a:ext cx="122833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/>
            <a:r>
              <a:rPr lang="en-GB" sz="1350" dirty="0">
                <a:solidFill>
                  <a:prstClr val="black"/>
                </a:solidFill>
                <a:latin typeface="Calibri" panose="020F0502020204030204"/>
              </a:rPr>
              <a:t>dermnetnz.or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B2D2CE-B2DF-E2D5-2A5A-6287F63BD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22674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7E3275-9A29-66D9-8B23-B2AE86844A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65BD2-5017-3DD7-D8D1-54B9EA22E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FDBE6C-F58D-2B4A-3C44-FD8933E16A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121275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B2F1E1-2617-0377-6224-A02062DE6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066196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E299F1-032D-F45B-75C8-44C802ECA6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28600" y="1295400"/>
            <a:ext cx="8229600" cy="5410200"/>
          </a:xfrm>
        </p:spPr>
        <p:txBody>
          <a:bodyPr>
            <a:normAutofit/>
          </a:bodyPr>
          <a:lstStyle/>
          <a:p>
            <a:r>
              <a:rPr lang="en-GB" sz="2100" u="sng" dirty="0">
                <a:latin typeface="Calibri" panose="020F0502020204030204" pitchFamily="34" charset="0"/>
              </a:rPr>
              <a:t>Which penicillin did you react to? </a:t>
            </a:r>
          </a:p>
          <a:p>
            <a:endParaRPr lang="en-GB" sz="2100" u="sng" dirty="0">
              <a:latin typeface="Calibri" panose="020F0502020204030204" pitchFamily="34" charset="0"/>
            </a:endParaRPr>
          </a:p>
          <a:p>
            <a:r>
              <a:rPr lang="en-GB" sz="2100" u="sng" dirty="0">
                <a:latin typeface="Calibri" panose="020F0502020204030204" pitchFamily="34" charset="0"/>
              </a:rPr>
              <a:t>What were the details of the reaction/what happened to you? </a:t>
            </a:r>
          </a:p>
          <a:p>
            <a:endParaRPr lang="en-GB" sz="2100" u="sng" dirty="0">
              <a:latin typeface="Calibri" panose="020F0502020204030204" pitchFamily="34" charset="0"/>
            </a:endParaRPr>
          </a:p>
          <a:p>
            <a:r>
              <a:rPr lang="en-GB" sz="2100" u="sng" dirty="0">
                <a:latin typeface="Calibri" panose="020F0502020204030204" pitchFamily="34" charset="0"/>
              </a:rPr>
              <a:t>How many hours after having your first dose of the antibiotic did the reaction occur?</a:t>
            </a:r>
          </a:p>
          <a:p>
            <a:endParaRPr lang="en-GB" sz="2100" u="sng" dirty="0">
              <a:latin typeface="Calibri" panose="020F0502020204030204" pitchFamily="34" charset="0"/>
            </a:endParaRPr>
          </a:p>
          <a:p>
            <a:r>
              <a:rPr lang="en-GB" sz="2100" u="sng" dirty="0">
                <a:latin typeface="Calibri" panose="020F0502020204030204" pitchFamily="34" charset="0"/>
              </a:rPr>
              <a:t>How many years ago did the reaction occur?</a:t>
            </a:r>
          </a:p>
          <a:p>
            <a:endParaRPr lang="en-GB" sz="2100" u="sng" dirty="0">
              <a:latin typeface="Calibri" panose="020F0502020204030204" pitchFamily="34" charset="0"/>
            </a:endParaRPr>
          </a:p>
          <a:p>
            <a:r>
              <a:rPr lang="en-GB" sz="2100" u="sng" dirty="0">
                <a:latin typeface="Calibri" panose="020F0502020204030204" pitchFamily="34" charset="0"/>
              </a:rPr>
              <a:t>How was the reaction managed? Did you need to go a hospital for treatment?</a:t>
            </a:r>
          </a:p>
          <a:p>
            <a:endParaRPr lang="en-GB" sz="2100" u="sng" dirty="0">
              <a:latin typeface="Calibri" panose="020F0502020204030204" pitchFamily="34" charset="0"/>
            </a:endParaRPr>
          </a:p>
          <a:p>
            <a:r>
              <a:rPr lang="en-GB" sz="2100" u="sng" dirty="0">
                <a:latin typeface="Calibri" panose="020F0502020204030204" pitchFamily="34" charset="0"/>
              </a:rPr>
              <a:t>Which other antibiotics have you tolerated post reaction (to check if the index penicillin or amoxicillin has since been tolerated)?</a:t>
            </a:r>
          </a:p>
          <a:p>
            <a:endParaRPr lang="en-GB" sz="1800" u="sng" dirty="0">
              <a:latin typeface="Calibri" panose="020F0502020204030204" pitchFamily="34" charset="0"/>
            </a:endParaRPr>
          </a:p>
          <a:p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B54B3E2-00C5-DFA7-35EF-825BCA1C957F}"/>
              </a:ext>
            </a:extLst>
          </p:cNvPr>
          <p:cNvSpPr txBox="1"/>
          <p:nvPr/>
        </p:nvSpPr>
        <p:spPr>
          <a:xfrm>
            <a:off x="609600" y="381000"/>
            <a:ext cx="7848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b="1" dirty="0"/>
              <a:t>Taking an allergy history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67C4D2A-3A19-CC67-3453-ECA0D0EC7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16047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991BD0F-3ECE-9BA4-8CB9-D413316D4A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1AC984-F3BA-895E-BF3C-31D26FA114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EA3EB8-A89B-64E9-6963-57DCB232C3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83162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77F0FD-21E3-E94D-E432-43D7E3042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499264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ecision support tool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dirty="0"/>
              <a:t>They help to risk stratify patients and help with assigning appropriate management.</a:t>
            </a:r>
          </a:p>
          <a:p>
            <a:r>
              <a:rPr lang="en-GB" dirty="0"/>
              <a:t>The tool by Devchand </a:t>
            </a:r>
            <a:r>
              <a:rPr lang="en-GB" i="1" dirty="0"/>
              <a:t>et al. </a:t>
            </a:r>
            <a:r>
              <a:rPr lang="en-GB" dirty="0"/>
              <a:t>helpfully groups the allergy histories by organ (dermatological, respiratory etc.) </a:t>
            </a:r>
          </a:p>
          <a:p>
            <a:r>
              <a:rPr lang="en-GB" dirty="0"/>
              <a:t>Decision tool in PADL guidelines. </a:t>
            </a:r>
          </a:p>
          <a:p>
            <a:pPr marL="0" indent="0">
              <a:buNone/>
            </a:pP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5A5CC9E-2F39-5D07-6BD4-D184FF960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28072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 descr="Please contact author or Governance Lead for further information.">
            <a:extLst>
              <a:ext uri="{FF2B5EF4-FFF2-40B4-BE49-F238E27FC236}">
                <a16:creationId xmlns:a16="http://schemas.microsoft.com/office/drawing/2014/main" id="{208FF255-34CA-253A-275A-726693C7C1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7199876"/>
              </p:ext>
            </p:extLst>
          </p:nvPr>
        </p:nvGraphicFramePr>
        <p:xfrm>
          <a:off x="-27039" y="-1"/>
          <a:ext cx="9174193" cy="68580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esentation" r:id="rId3" imgW="4572300" imgH="3429307" progId="PowerPoint.Show.12">
                  <p:embed/>
                </p:oleObj>
              </mc:Choice>
              <mc:Fallback>
                <p:oleObj name="Presentation" r:id="rId3" imgW="4572300" imgH="3429307" progId="PowerPoint.Show.12">
                  <p:embed/>
                  <p:pic>
                    <p:nvPicPr>
                      <p:cNvPr id="0" name="Object 3" descr="Please contact author or Governance Lead for further information.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27039" y="-1"/>
                        <a:ext cx="9174193" cy="685800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3C4F453-BF48-E0B3-6667-366C343B8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92854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991BD0F-3ECE-9BA4-8CB9-D413316D4A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1AC984-F3BA-895E-BF3C-31D26FA114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EA3EB8-A89B-64E9-6963-57DCB232C3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83162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77F0FD-21E3-E94D-E432-43D7E3042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7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067984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anag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GB" b="1" dirty="0"/>
              <a:t>Intolerances </a:t>
            </a:r>
          </a:p>
          <a:p>
            <a:pPr lvl="1"/>
            <a:r>
              <a:rPr lang="en-GB" sz="3200" dirty="0"/>
              <a:t>Non-immune mediated, non-severe events</a:t>
            </a:r>
          </a:p>
          <a:p>
            <a:pPr lvl="1"/>
            <a:r>
              <a:rPr lang="en-GB" sz="3200" dirty="0"/>
              <a:t>Includes: nausea, vomiting, diarrhoea, thrush, headache</a:t>
            </a:r>
          </a:p>
          <a:p>
            <a:r>
              <a:rPr lang="en-GB" b="1" dirty="0"/>
              <a:t>Other</a:t>
            </a:r>
            <a:r>
              <a:rPr lang="en-GB" dirty="0"/>
              <a:t>: family history of penicillin allergy but non-exposure of patient.</a:t>
            </a:r>
            <a:endParaRPr lang="en-GB" b="1" dirty="0"/>
          </a:p>
          <a:p>
            <a:r>
              <a:rPr lang="en-GB" b="1" dirty="0"/>
              <a:t>Management</a:t>
            </a:r>
            <a:r>
              <a:rPr lang="en-GB" dirty="0"/>
              <a:t> – direct de-label. If the patient would be reassured by a direct oral challenge (DOC) then offer DOC, but if therapeutic de-label then initiate penicillin without DOC</a:t>
            </a:r>
          </a:p>
          <a:p>
            <a:pPr marL="0" indent="0" algn="r">
              <a:buNone/>
            </a:pPr>
            <a:r>
              <a:rPr lang="en-GB" sz="2000" i="1" dirty="0"/>
              <a:t>Devchand AAAT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8A44B1-ABC5-4BA4-D0D5-0299E72A9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3173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j-ea"/>
                <a:cs typeface="+mj-cs"/>
              </a:rPr>
              <a:t>Management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GB" b="1" dirty="0"/>
              <a:t>Low risk </a:t>
            </a:r>
          </a:p>
          <a:p>
            <a:pPr lvl="1"/>
            <a:r>
              <a:rPr lang="en-GB" dirty="0"/>
              <a:t>Childhood exanthem without severe features,</a:t>
            </a:r>
          </a:p>
          <a:p>
            <a:pPr lvl="1"/>
            <a:r>
              <a:rPr lang="en-GB" dirty="0"/>
              <a:t>Diffuse rash without severe features &gt;10 years ago, </a:t>
            </a:r>
          </a:p>
          <a:p>
            <a:pPr lvl="1"/>
            <a:r>
              <a:rPr lang="en-GB" dirty="0"/>
              <a:t>Unknown reaction &gt;10 years ago (inc. unknown childhood reaction).</a:t>
            </a:r>
          </a:p>
          <a:p>
            <a:r>
              <a:rPr lang="en-GB" dirty="0"/>
              <a:t>Offer a </a:t>
            </a:r>
            <a:r>
              <a:rPr lang="en-GB" b="1" u="sng" dirty="0"/>
              <a:t>direct oral challenge </a:t>
            </a:r>
            <a:r>
              <a:rPr lang="en-GB" dirty="0"/>
              <a:t>with amoxicillin single dose 500mg and observe for 60 minutes. </a:t>
            </a:r>
          </a:p>
          <a:p>
            <a:pPr marL="0" lvl="0" indent="0" algn="r">
              <a:buNone/>
            </a:pPr>
            <a:r>
              <a:rPr lang="en-GB" sz="2000" i="1" dirty="0">
                <a:solidFill>
                  <a:prstClr val="black"/>
                </a:solidFill>
              </a:rPr>
              <a:t>Devchand AAAT</a:t>
            </a:r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FF9812-2F6F-D5CE-7000-A345A9127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242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234F0-457D-05C2-3E96-6F5A02185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A49A07-7AE3-C7D2-D2EB-D7AC37A999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4983162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AFDA47-5EAB-77D9-2DE0-D97CC13C6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9669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6311"/>
    </mc:Choice>
    <mc:Fallback xmlns="">
      <p:transition spd="slow" advTm="36311"/>
    </mc:Fallback>
  </mc:AlternateContent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j-ea"/>
                <a:cs typeface="+mj-cs"/>
              </a:rPr>
              <a:t>Management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b="1" dirty="0"/>
              <a:t>Moderate risk</a:t>
            </a:r>
          </a:p>
          <a:p>
            <a:pPr lvl="1"/>
            <a:r>
              <a:rPr lang="en-GB" dirty="0"/>
              <a:t>Immediate diffuse rash (&lt;2 hours post dose), angioedema, generalised swelling, urticaria, throat tightness, respiratory compromise, </a:t>
            </a:r>
          </a:p>
          <a:p>
            <a:pPr lvl="1"/>
            <a:r>
              <a:rPr lang="en-GB" dirty="0"/>
              <a:t>unknown reaction &lt;10 years ago, </a:t>
            </a:r>
          </a:p>
          <a:p>
            <a:pPr lvl="1"/>
            <a:r>
              <a:rPr lang="en-GB" dirty="0"/>
              <a:t>seizures.</a:t>
            </a:r>
          </a:p>
          <a:p>
            <a:r>
              <a:rPr lang="en-GB" b="1" dirty="0"/>
              <a:t>Allergist assessment </a:t>
            </a:r>
            <a:r>
              <a:rPr lang="en-GB" dirty="0"/>
              <a:t>(if able) or exclude. </a:t>
            </a:r>
          </a:p>
          <a:p>
            <a:r>
              <a:rPr lang="en-GB" dirty="0"/>
              <a:t>These patients with require SPT/IDT &amp; </a:t>
            </a:r>
            <a:r>
              <a:rPr lang="en-GB" dirty="0" err="1"/>
              <a:t>SpIgE</a:t>
            </a:r>
            <a:r>
              <a:rPr lang="en-GB" dirty="0"/>
              <a:t> testing prior to the oral challenge.</a:t>
            </a:r>
          </a:p>
          <a:p>
            <a:pPr marL="0" lvl="0" indent="0" algn="r">
              <a:buNone/>
            </a:pPr>
            <a:r>
              <a:rPr lang="en-GB" sz="2000" i="1" dirty="0" err="1">
                <a:solidFill>
                  <a:prstClr val="black"/>
                </a:solidFill>
              </a:rPr>
              <a:t>Devchand</a:t>
            </a:r>
            <a:r>
              <a:rPr lang="en-GB" sz="2000" i="1" dirty="0">
                <a:solidFill>
                  <a:prstClr val="black"/>
                </a:solidFill>
              </a:rPr>
              <a:t> AAAT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EC5826-E457-7478-0787-C9DE7D642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31409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j-ea"/>
                <a:cs typeface="+mj-cs"/>
              </a:rPr>
              <a:t>Management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b="1" dirty="0"/>
              <a:t>High risk </a:t>
            </a:r>
          </a:p>
          <a:p>
            <a:pPr lvl="1"/>
            <a:r>
              <a:rPr lang="en-GB" dirty="0"/>
              <a:t>Mucosal ulceration, pustular, blistering or desquamating rash, fever not explained by infection, anaphylaxis or collapse, bone marrow suppression, eosinophilia, severe renal injury, severe liver injury, </a:t>
            </a:r>
          </a:p>
          <a:p>
            <a:r>
              <a:rPr lang="en-GB" b="1" dirty="0"/>
              <a:t>Allergist assessment </a:t>
            </a:r>
            <a:r>
              <a:rPr lang="en-GB" dirty="0"/>
              <a:t>(If able), or exclude</a:t>
            </a:r>
            <a:endParaRPr lang="en-GB" b="1" dirty="0"/>
          </a:p>
          <a:p>
            <a:endParaRPr lang="en-GB" dirty="0"/>
          </a:p>
          <a:p>
            <a:pPr marL="0" indent="0" algn="r">
              <a:buNone/>
            </a:pPr>
            <a:r>
              <a:rPr lang="en-GB" sz="1900" i="1" dirty="0">
                <a:solidFill>
                  <a:prstClr val="black"/>
                </a:solidFill>
              </a:rPr>
              <a:t>Devchand AAAT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51A749-4C48-68C8-47FF-659CDD4BA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69863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33FF9-8F61-80A4-B656-A03D557EF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anag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A71189-89D3-7308-FFB5-7BB21600BB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dirty="0"/>
              <a:t>Managing patients who have tolerated a penicillin since the index reaction is nuanced.</a:t>
            </a:r>
          </a:p>
          <a:p>
            <a:r>
              <a:rPr lang="en-GB" dirty="0"/>
              <a:t>A history consistent with a low-risk allergy history that meets criteria for a DOC test but has tolerated any penicillin since the index reaction – DDL</a:t>
            </a:r>
          </a:p>
          <a:p>
            <a:r>
              <a:rPr lang="en-GB" dirty="0"/>
              <a:t>A history consistent with an </a:t>
            </a:r>
            <a:r>
              <a:rPr lang="en-GB" dirty="0" err="1"/>
              <a:t>IgE</a:t>
            </a:r>
            <a:r>
              <a:rPr lang="en-GB" dirty="0"/>
              <a:t> mediated reaction – depends on index penicillin and tolerated penicillin – see RCHT PADL for more detail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4AF381-6346-AEE4-5BA4-793CDC0C8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62164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7F27E9-E46B-C1F2-F7EF-6B7AC1255B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D47D6-93CA-8719-84F9-3D32748CF5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92E9E9-F047-120D-F260-05B49D955B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121275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C6E802-CFE0-9372-4E66-1EAAE7347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001362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08AFC-7943-E13D-3EF9-640D46F9C3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944562"/>
          </a:xfrm>
        </p:spPr>
        <p:txBody>
          <a:bodyPr/>
          <a:lstStyle/>
          <a:p>
            <a:r>
              <a:rPr lang="en-GB" dirty="0"/>
              <a:t>Then document this in EPM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CAD771-D601-59B3-078E-85D56F7771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373188"/>
            <a:ext cx="8229600" cy="5210174"/>
          </a:xfrm>
        </p:spPr>
        <p:txBody>
          <a:bodyPr>
            <a:normAutofit fontScale="85000" lnSpcReduction="20000"/>
          </a:bodyPr>
          <a:lstStyle/>
          <a:p>
            <a:r>
              <a:rPr lang="en-GB" dirty="0"/>
              <a:t>Cut and paste the questions and the answers into a ‘Pharmaceutical Care Plan’ note in EPMA.</a:t>
            </a:r>
          </a:p>
          <a:p>
            <a:r>
              <a:rPr lang="en-GB" dirty="0"/>
              <a:t>Add title that reflects the outcome of the allergy risk assessment. </a:t>
            </a:r>
          </a:p>
          <a:p>
            <a:pPr lvl="1"/>
            <a:r>
              <a:rPr lang="en-GB" dirty="0"/>
              <a:t>PADL HIGH</a:t>
            </a:r>
          </a:p>
          <a:p>
            <a:pPr lvl="1"/>
            <a:r>
              <a:rPr lang="en-GB" dirty="0"/>
              <a:t>PADL LOW DDL</a:t>
            </a:r>
          </a:p>
          <a:p>
            <a:pPr lvl="1"/>
            <a:r>
              <a:rPr lang="en-GB" dirty="0"/>
              <a:t>PADL LOW DOC</a:t>
            </a:r>
          </a:p>
          <a:p>
            <a:pPr lvl="1"/>
            <a:r>
              <a:rPr lang="en-GB" dirty="0"/>
              <a:t>PADL unable to obtain history (revisit)</a:t>
            </a:r>
          </a:p>
          <a:p>
            <a:pPr lvl="1"/>
            <a:r>
              <a:rPr lang="en-GB" dirty="0"/>
              <a:t>PADL unable to obtain history</a:t>
            </a:r>
          </a:p>
          <a:p>
            <a:r>
              <a:rPr lang="en-GB" dirty="0" err="1"/>
              <a:t>PenA</a:t>
            </a:r>
            <a:r>
              <a:rPr lang="en-GB" dirty="0"/>
              <a:t> questions PADL guidelines or ‘pharmacy reports’ folder.</a:t>
            </a:r>
          </a:p>
          <a:p>
            <a:r>
              <a:rPr lang="en-GB" dirty="0"/>
              <a:t>Flag for others (ward teams and AMS teams); a two step process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20E235-C4BE-DA98-7E81-60783F3F1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514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1BBF80CB-71C3-0795-44F8-F3CE202C1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5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7E5ED3F-9B0C-9590-ECF8-142D3A3271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526977" y="0"/>
            <a:ext cx="12197953" cy="6858000"/>
          </a:xfrm>
          <a:prstGeom prst="rect">
            <a:avLst/>
          </a:prstGeom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5" name="Ink 4">
                <a:extLst>
                  <a:ext uri="{FF2B5EF4-FFF2-40B4-BE49-F238E27FC236}">
                    <a16:creationId xmlns:a16="http://schemas.microsoft.com/office/drawing/2014/main" id="{F2CD8BA1-3968-B0E0-7649-87F2F3B876F0}"/>
                  </a:ext>
                </a:extLst>
              </p14:cNvPr>
              <p14:cNvContentPartPr/>
              <p14:nvPr/>
            </p14:nvContentPartPr>
            <p14:xfrm>
              <a:off x="397290" y="3337170"/>
              <a:ext cx="3461400" cy="483840"/>
            </p14:xfrm>
          </p:contentPart>
        </mc:Choice>
        <mc:Fallback xmlns="">
          <p:pic>
            <p:nvPicPr>
              <p:cNvPr id="5" name="Ink 4">
                <a:extLst>
                  <a:ext uri="{FF2B5EF4-FFF2-40B4-BE49-F238E27FC236}">
                    <a16:creationId xmlns:a16="http://schemas.microsoft.com/office/drawing/2014/main" id="{F2CD8BA1-3968-B0E0-7649-87F2F3B876F0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88290" y="3328530"/>
                <a:ext cx="3479040" cy="50148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7" name="Ink 6">
                <a:extLst>
                  <a:ext uri="{FF2B5EF4-FFF2-40B4-BE49-F238E27FC236}">
                    <a16:creationId xmlns:a16="http://schemas.microsoft.com/office/drawing/2014/main" id="{2BEE0F7D-EAB8-8F3C-B2A8-21501A8ADD63}"/>
                  </a:ext>
                </a:extLst>
              </p14:cNvPr>
              <p14:cNvContentPartPr/>
              <p14:nvPr/>
            </p14:nvContentPartPr>
            <p14:xfrm>
              <a:off x="359490" y="4171290"/>
              <a:ext cx="6956640" cy="1848240"/>
            </p14:xfrm>
          </p:contentPart>
        </mc:Choice>
        <mc:Fallback xmlns="">
          <p:pic>
            <p:nvPicPr>
              <p:cNvPr id="7" name="Ink 6">
                <a:extLst>
                  <a:ext uri="{FF2B5EF4-FFF2-40B4-BE49-F238E27FC236}">
                    <a16:creationId xmlns:a16="http://schemas.microsoft.com/office/drawing/2014/main" id="{2BEE0F7D-EAB8-8F3C-B2A8-21501A8ADD63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50490" y="4162290"/>
                <a:ext cx="6974280" cy="186588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8" name="Ink 7">
                <a:extLst>
                  <a:ext uri="{FF2B5EF4-FFF2-40B4-BE49-F238E27FC236}">
                    <a16:creationId xmlns:a16="http://schemas.microsoft.com/office/drawing/2014/main" id="{17A51586-1944-C1C9-064C-6C96F0BB0373}"/>
                  </a:ext>
                </a:extLst>
              </p14:cNvPr>
              <p14:cNvContentPartPr/>
              <p14:nvPr/>
            </p14:nvContentPartPr>
            <p14:xfrm>
              <a:off x="413130" y="3017490"/>
              <a:ext cx="646560" cy="268920"/>
            </p14:xfrm>
          </p:contentPart>
        </mc:Choice>
        <mc:Fallback xmlns="">
          <p:pic>
            <p:nvPicPr>
              <p:cNvPr id="8" name="Ink 7">
                <a:extLst>
                  <a:ext uri="{FF2B5EF4-FFF2-40B4-BE49-F238E27FC236}">
                    <a16:creationId xmlns:a16="http://schemas.microsoft.com/office/drawing/2014/main" id="{17A51586-1944-C1C9-064C-6C96F0BB0373}"/>
                  </a:ext>
                </a:extLst>
              </p:cNvPr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04130" y="3008850"/>
                <a:ext cx="664200" cy="2865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9">
            <p14:nvContentPartPr>
              <p14:cNvPr id="9" name="Ink 8">
                <a:extLst>
                  <a:ext uri="{FF2B5EF4-FFF2-40B4-BE49-F238E27FC236}">
                    <a16:creationId xmlns:a16="http://schemas.microsoft.com/office/drawing/2014/main" id="{97BFF40E-D0B4-4F10-9B90-D30EA39E4E0E}"/>
                  </a:ext>
                </a:extLst>
              </p14:cNvPr>
              <p14:cNvContentPartPr/>
              <p14:nvPr/>
            </p14:nvContentPartPr>
            <p14:xfrm>
              <a:off x="7932090" y="6276885"/>
              <a:ext cx="536760" cy="239400"/>
            </p14:xfrm>
          </p:contentPart>
        </mc:Choice>
        <mc:Fallback xmlns="">
          <p:pic>
            <p:nvPicPr>
              <p:cNvPr id="9" name="Ink 8">
                <a:extLst>
                  <a:ext uri="{FF2B5EF4-FFF2-40B4-BE49-F238E27FC236}">
                    <a16:creationId xmlns:a16="http://schemas.microsoft.com/office/drawing/2014/main" id="{97BFF40E-D0B4-4F10-9B90-D30EA39E4E0E}"/>
                  </a:ext>
                </a:extLst>
              </p:cNvPr>
              <p:cNvPicPr/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7923090" y="6267885"/>
                <a:ext cx="554400" cy="2570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1">
            <p14:nvContentPartPr>
              <p14:cNvPr id="10" name="Ink 9">
                <a:extLst>
                  <a:ext uri="{FF2B5EF4-FFF2-40B4-BE49-F238E27FC236}">
                    <a16:creationId xmlns:a16="http://schemas.microsoft.com/office/drawing/2014/main" id="{42BC8705-05BD-E6A6-6CC0-C926391D680A}"/>
                  </a:ext>
                </a:extLst>
              </p14:cNvPr>
              <p14:cNvContentPartPr/>
              <p14:nvPr/>
            </p14:nvContentPartPr>
            <p14:xfrm>
              <a:off x="952410" y="3028605"/>
              <a:ext cx="360" cy="360"/>
            </p14:xfrm>
          </p:contentPart>
        </mc:Choice>
        <mc:Fallback xmlns="">
          <p:pic>
            <p:nvPicPr>
              <p:cNvPr id="10" name="Ink 9">
                <a:extLst>
                  <a:ext uri="{FF2B5EF4-FFF2-40B4-BE49-F238E27FC236}">
                    <a16:creationId xmlns:a16="http://schemas.microsoft.com/office/drawing/2014/main" id="{42BC8705-05BD-E6A6-6CC0-C926391D680A}"/>
                  </a:ext>
                </a:extLst>
              </p:cNvPr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943410" y="3019605"/>
                <a:ext cx="18000" cy="18000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20538204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8A9E36F-FADC-22E9-790A-1169C4B9D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6</a:t>
            </a:fld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2A7A1F-3AA6-B73A-872F-8A46110CB6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50791"/>
            <a:ext cx="9144000" cy="4956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146385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60A270-0069-C187-CB5E-37AF83C3A7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B2D833-AACD-9C0C-4F16-AEA2052AAD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7AEF6D-DCFA-B8F4-FFE0-B3D9E616FD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83162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8631E6-79A6-D248-BC44-AE50F5350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7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561142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3C6F77-79EB-A6C7-C64E-77F7366FF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De-label methods DDL</a:t>
            </a:r>
            <a:br>
              <a:rPr lang="en-GB" dirty="0"/>
            </a:br>
            <a:r>
              <a:rPr lang="en-GB" sz="3600" dirty="0"/>
              <a:t>‘Direct de-label’ or de-label on history alon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B17AE2-39EE-6C4D-0162-4562F67D0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F53B9C7-DB93-01FC-E9F7-1810F5B97208}"/>
              </a:ext>
            </a:extLst>
          </p:cNvPr>
          <p:cNvSpPr/>
          <p:nvPr/>
        </p:nvSpPr>
        <p:spPr>
          <a:xfrm>
            <a:off x="5646057" y="3886200"/>
            <a:ext cx="33147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mail GP surgery with dedicated letter (proforma in RCHT PADL guidelines (preferred method)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FF19237-0A56-DEC9-C210-1B5C6FD4E297}"/>
              </a:ext>
            </a:extLst>
          </p:cNvPr>
          <p:cNvSpPr/>
          <p:nvPr/>
        </p:nvSpPr>
        <p:spPr>
          <a:xfrm>
            <a:off x="3497944" y="4220653"/>
            <a:ext cx="13716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nform GP of new allergy status 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08C83EB-B764-84CF-66D2-4C72C546C93A}"/>
              </a:ext>
            </a:extLst>
          </p:cNvPr>
          <p:cNvSpPr/>
          <p:nvPr/>
        </p:nvSpPr>
        <p:spPr>
          <a:xfrm>
            <a:off x="5638800" y="4892675"/>
            <a:ext cx="2059214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Note to appear in discharge letter’ note in EPMA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E5AC05A-8C79-5375-B542-43C270A80C18}"/>
              </a:ext>
            </a:extLst>
          </p:cNvPr>
          <p:cNvSpPr/>
          <p:nvPr/>
        </p:nvSpPr>
        <p:spPr>
          <a:xfrm>
            <a:off x="5671457" y="5899150"/>
            <a:ext cx="13716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charge letter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C45C1D8-B33B-6C40-0C13-C64094B04EA9}"/>
              </a:ext>
            </a:extLst>
          </p:cNvPr>
          <p:cNvSpPr/>
          <p:nvPr/>
        </p:nvSpPr>
        <p:spPr>
          <a:xfrm>
            <a:off x="3461657" y="2942147"/>
            <a:ext cx="13716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move </a:t>
            </a:r>
            <a:r>
              <a:rPr kumimoji="0" lang="en-GB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enA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record from EPMA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5A091A5-1D28-D0E1-1425-F22B9D96E08F}"/>
              </a:ext>
            </a:extLst>
          </p:cNvPr>
          <p:cNvSpPr/>
          <p:nvPr/>
        </p:nvSpPr>
        <p:spPr>
          <a:xfrm>
            <a:off x="3461657" y="1691934"/>
            <a:ext cx="13716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nformed patient verbal consent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F961BF1-5E39-68B3-DB79-ECB7913A7C44}"/>
              </a:ext>
            </a:extLst>
          </p:cNvPr>
          <p:cNvSpPr/>
          <p:nvPr/>
        </p:nvSpPr>
        <p:spPr>
          <a:xfrm>
            <a:off x="119743" y="1691934"/>
            <a:ext cx="28194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xplain the risks of having an incorrect </a:t>
            </a:r>
            <a:r>
              <a:rPr kumimoji="0" lang="en-GB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enA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use PIL in RCHT PADL guideline).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599AAA5-9AF4-6DA4-AE32-C59D22A903CA}"/>
              </a:ext>
            </a:extLst>
          </p:cNvPr>
          <p:cNvCxnSpPr>
            <a:cxnSpLocks/>
          </p:cNvCxnSpPr>
          <p:nvPr/>
        </p:nvCxnSpPr>
        <p:spPr>
          <a:xfrm>
            <a:off x="3048000" y="2149134"/>
            <a:ext cx="3048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4F396DB-238D-5272-5D3A-8622F7A39A87}"/>
              </a:ext>
            </a:extLst>
          </p:cNvPr>
          <p:cNvCxnSpPr>
            <a:cxnSpLocks/>
          </p:cNvCxnSpPr>
          <p:nvPr/>
        </p:nvCxnSpPr>
        <p:spPr>
          <a:xfrm>
            <a:off x="4154714" y="2606334"/>
            <a:ext cx="0" cy="2744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C38D132-7C9F-9D7A-2303-5A720A57AAB4}"/>
              </a:ext>
            </a:extLst>
          </p:cNvPr>
          <p:cNvCxnSpPr>
            <a:cxnSpLocks/>
          </p:cNvCxnSpPr>
          <p:nvPr/>
        </p:nvCxnSpPr>
        <p:spPr>
          <a:xfrm>
            <a:off x="5058230" y="4343400"/>
            <a:ext cx="3048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2BCDA7C-05A0-2D22-8ECC-45FB2E50C49D}"/>
              </a:ext>
            </a:extLst>
          </p:cNvPr>
          <p:cNvCxnSpPr>
            <a:cxnSpLocks/>
          </p:cNvCxnSpPr>
          <p:nvPr/>
        </p:nvCxnSpPr>
        <p:spPr>
          <a:xfrm>
            <a:off x="5021944" y="4940271"/>
            <a:ext cx="304800" cy="2423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352CD01-38BA-8099-5158-41C75BD50310}"/>
              </a:ext>
            </a:extLst>
          </p:cNvPr>
          <p:cNvCxnSpPr>
            <a:cxnSpLocks/>
          </p:cNvCxnSpPr>
          <p:nvPr/>
        </p:nvCxnSpPr>
        <p:spPr>
          <a:xfrm>
            <a:off x="4753430" y="5731923"/>
            <a:ext cx="304800" cy="3344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60E528AD-64E9-0295-AEF2-E39552018571}"/>
              </a:ext>
            </a:extLst>
          </p:cNvPr>
          <p:cNvCxnSpPr>
            <a:cxnSpLocks/>
          </p:cNvCxnSpPr>
          <p:nvPr/>
        </p:nvCxnSpPr>
        <p:spPr>
          <a:xfrm>
            <a:off x="4201887" y="3886200"/>
            <a:ext cx="0" cy="304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31714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 animBg="1"/>
      <p:bldP spid="7" grpId="0" animBg="1"/>
      <p:bldP spid="8" grpId="0" animBg="1"/>
      <p:bldP spid="9" grpId="0" animBg="1"/>
      <p:bldP spid="10" grpId="0" animBg="1"/>
      <p:bldP spid="11" grpId="0" animBg="1"/>
    </p:bld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0FDE4-E80E-6A51-91C0-497384616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5057" y="46987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dirty="0"/>
              <a:t>De-label methods DOC</a:t>
            </a:r>
            <a:br>
              <a:rPr lang="en-GB" dirty="0"/>
            </a:br>
            <a:r>
              <a:rPr lang="en-GB" sz="3600" dirty="0"/>
              <a:t>‘Direct oral challenge’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2FE089-6F38-7D84-B806-AC5122973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9</a:t>
            </a:fld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F463A92-5D21-6D7B-B5A5-7E2FC52E309C}"/>
              </a:ext>
            </a:extLst>
          </p:cNvPr>
          <p:cNvSpPr/>
          <p:nvPr/>
        </p:nvSpPr>
        <p:spPr>
          <a:xfrm>
            <a:off x="124566" y="1319271"/>
            <a:ext cx="28194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Explain the risks of having an incorrect </a:t>
            </a:r>
            <a:r>
              <a:rPr lang="en-GB" sz="1600" dirty="0" err="1"/>
              <a:t>penA</a:t>
            </a:r>
            <a:r>
              <a:rPr lang="en-GB" sz="1600" dirty="0"/>
              <a:t> (use PIL in RCHT PADL guideline).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C403131-F740-2555-E05A-7A668D8FD698}"/>
              </a:ext>
            </a:extLst>
          </p:cNvPr>
          <p:cNvSpPr/>
          <p:nvPr/>
        </p:nvSpPr>
        <p:spPr>
          <a:xfrm>
            <a:off x="3382305" y="1319271"/>
            <a:ext cx="1371600" cy="91440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Informed patient verbal consent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BE1A87F-3FDC-0BA8-B2E8-F6B8261D681B}"/>
              </a:ext>
            </a:extLst>
          </p:cNvPr>
          <p:cNvSpPr/>
          <p:nvPr/>
        </p:nvSpPr>
        <p:spPr>
          <a:xfrm>
            <a:off x="150785" y="2928673"/>
            <a:ext cx="2171230" cy="1648965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Undertake, or delegate, required baseline observations and post provocation test observations (see RCHT PADL guidelines)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85C483D-7EAE-C224-C11D-689B072F19E6}"/>
              </a:ext>
            </a:extLst>
          </p:cNvPr>
          <p:cNvSpPr/>
          <p:nvPr/>
        </p:nvSpPr>
        <p:spPr>
          <a:xfrm>
            <a:off x="2962832" y="2989530"/>
            <a:ext cx="2497309" cy="1226147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Prescribe oral challenge dose (single adult oral dose of index penicillin or amoxicillin, if index unknown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3DFCA5D-CB50-7D37-B06F-AFCD286CB4EA}"/>
              </a:ext>
            </a:extLst>
          </p:cNvPr>
          <p:cNvSpPr/>
          <p:nvPr/>
        </p:nvSpPr>
        <p:spPr>
          <a:xfrm>
            <a:off x="5304381" y="1319271"/>
            <a:ext cx="3665621" cy="132166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GB" sz="1600" dirty="0"/>
              <a:t>Check the patient does not meet any exclusion criteria for a direct oral challenge test (e.g. patient unable to give history, haemodynamic instability, concurrent antihistamine therapy etc). 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E91D99A-1D80-B121-C94C-58AC69A1D84A}"/>
              </a:ext>
            </a:extLst>
          </p:cNvPr>
          <p:cNvSpPr/>
          <p:nvPr/>
        </p:nvSpPr>
        <p:spPr>
          <a:xfrm>
            <a:off x="6126078" y="2989530"/>
            <a:ext cx="2057399" cy="1267536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Seek permission from senior responsible clinician prior to provocation testing.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88AF84C-5869-71F1-A11E-927ADE79CFA8}"/>
              </a:ext>
            </a:extLst>
          </p:cNvPr>
          <p:cNvCxnSpPr>
            <a:cxnSpLocks/>
          </p:cNvCxnSpPr>
          <p:nvPr/>
        </p:nvCxnSpPr>
        <p:spPr>
          <a:xfrm>
            <a:off x="3026390" y="1741963"/>
            <a:ext cx="3048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AEE4CC9-F850-8BE3-016A-6EB9737B946F}"/>
              </a:ext>
            </a:extLst>
          </p:cNvPr>
          <p:cNvCxnSpPr>
            <a:cxnSpLocks/>
          </p:cNvCxnSpPr>
          <p:nvPr/>
        </p:nvCxnSpPr>
        <p:spPr>
          <a:xfrm>
            <a:off x="7104209" y="2640933"/>
            <a:ext cx="0" cy="304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CF698C9-1786-D957-400D-EB1FB13C74C6}"/>
              </a:ext>
            </a:extLst>
          </p:cNvPr>
          <p:cNvCxnSpPr>
            <a:cxnSpLocks/>
          </p:cNvCxnSpPr>
          <p:nvPr/>
        </p:nvCxnSpPr>
        <p:spPr>
          <a:xfrm>
            <a:off x="4882998" y="1776471"/>
            <a:ext cx="3048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C3D02F7-07E2-B4CB-85CC-E948E3B250A3}"/>
              </a:ext>
            </a:extLst>
          </p:cNvPr>
          <p:cNvCxnSpPr>
            <a:cxnSpLocks/>
          </p:cNvCxnSpPr>
          <p:nvPr/>
        </p:nvCxnSpPr>
        <p:spPr>
          <a:xfrm flipH="1">
            <a:off x="5638800" y="3632644"/>
            <a:ext cx="3986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5F52925D-8B95-9290-64E6-81AC38D53D86}"/>
              </a:ext>
            </a:extLst>
          </p:cNvPr>
          <p:cNvCxnSpPr>
            <a:cxnSpLocks/>
          </p:cNvCxnSpPr>
          <p:nvPr/>
        </p:nvCxnSpPr>
        <p:spPr>
          <a:xfrm flipH="1">
            <a:off x="2438400" y="3632644"/>
            <a:ext cx="39808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EDE1DACE-60C3-1CE3-7F19-1AC83F674E16}"/>
              </a:ext>
            </a:extLst>
          </p:cNvPr>
          <p:cNvCxnSpPr>
            <a:cxnSpLocks/>
          </p:cNvCxnSpPr>
          <p:nvPr/>
        </p:nvCxnSpPr>
        <p:spPr>
          <a:xfrm>
            <a:off x="838200" y="4724400"/>
            <a:ext cx="0" cy="304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6C624940-12C9-F895-7356-38CD2E50271B}"/>
              </a:ext>
            </a:extLst>
          </p:cNvPr>
          <p:cNvSpPr/>
          <p:nvPr/>
        </p:nvSpPr>
        <p:spPr>
          <a:xfrm>
            <a:off x="124566" y="5135563"/>
            <a:ext cx="1704234" cy="158591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If there is no reaction within first 60 minutes, then immediate hypersensitivity can be ruled out.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66F4DC5-FA63-40D4-730C-1A9AC4062908}"/>
              </a:ext>
            </a:extLst>
          </p:cNvPr>
          <p:cNvSpPr/>
          <p:nvPr/>
        </p:nvSpPr>
        <p:spPr>
          <a:xfrm>
            <a:off x="6080990" y="5766131"/>
            <a:ext cx="3020174" cy="1091869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‘Note to appear in discharge letter’ note in EP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Discharge letter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53A2922-A0E5-7DDA-64E0-208AB7E29308}"/>
              </a:ext>
            </a:extLst>
          </p:cNvPr>
          <p:cNvSpPr/>
          <p:nvPr/>
        </p:nvSpPr>
        <p:spPr>
          <a:xfrm>
            <a:off x="6092364" y="4538883"/>
            <a:ext cx="3008800" cy="1236337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Email GP surgery with dedicated letter (proforma in RCHT PADL guidelines (preferred method)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D57679D-AEC4-9368-FF17-FBA2810AF9D5}"/>
              </a:ext>
            </a:extLst>
          </p:cNvPr>
          <p:cNvSpPr/>
          <p:nvPr/>
        </p:nvSpPr>
        <p:spPr>
          <a:xfrm>
            <a:off x="4169278" y="5180965"/>
            <a:ext cx="1135104" cy="154050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Inform GP of new allergy status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CF965DA-F39D-FDEB-C37A-9E1931D5DF63}"/>
              </a:ext>
            </a:extLst>
          </p:cNvPr>
          <p:cNvSpPr/>
          <p:nvPr/>
        </p:nvSpPr>
        <p:spPr>
          <a:xfrm>
            <a:off x="2160844" y="5180964"/>
            <a:ext cx="1704234" cy="154050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/>
              <a:t>Counsel patient on the small risk (1-2%) of a delayed mild skin reaction in the next 5 – 10 days.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EBBD9791-4C95-C02A-890F-F95060D1B1D9}"/>
              </a:ext>
            </a:extLst>
          </p:cNvPr>
          <p:cNvCxnSpPr>
            <a:cxnSpLocks/>
          </p:cNvCxnSpPr>
          <p:nvPr/>
        </p:nvCxnSpPr>
        <p:spPr>
          <a:xfrm>
            <a:off x="5460141" y="6172200"/>
            <a:ext cx="39974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C9E46752-6EFC-1F6F-CC76-8419CF181DD8}"/>
              </a:ext>
            </a:extLst>
          </p:cNvPr>
          <p:cNvCxnSpPr>
            <a:cxnSpLocks/>
          </p:cNvCxnSpPr>
          <p:nvPr/>
        </p:nvCxnSpPr>
        <p:spPr>
          <a:xfrm>
            <a:off x="5460141" y="5334000"/>
            <a:ext cx="381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4CC47731-6E4F-B22B-86DC-8EAD554495D9}"/>
              </a:ext>
            </a:extLst>
          </p:cNvPr>
          <p:cNvCxnSpPr>
            <a:cxnSpLocks/>
          </p:cNvCxnSpPr>
          <p:nvPr/>
        </p:nvCxnSpPr>
        <p:spPr>
          <a:xfrm>
            <a:off x="3865078" y="5869675"/>
            <a:ext cx="2286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CC57234F-1794-B214-5F62-7384CDABFFC7}"/>
              </a:ext>
            </a:extLst>
          </p:cNvPr>
          <p:cNvCxnSpPr>
            <a:cxnSpLocks/>
          </p:cNvCxnSpPr>
          <p:nvPr/>
        </p:nvCxnSpPr>
        <p:spPr>
          <a:xfrm>
            <a:off x="1828800" y="5867400"/>
            <a:ext cx="3320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39957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fill="hold">
                      <p:stCondLst>
                        <p:cond delay="indefinite"/>
                      </p:stCondLst>
                      <p:childTnLst>
                        <p:par>
                          <p:cTn id="56" fill="hold">
                            <p:stCondLst>
                              <p:cond delay="0"/>
                            </p:stCondLst>
                            <p:childTnLst>
                              <p:par>
                                <p:cTn id="5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1" fill="hold">
                      <p:stCondLst>
                        <p:cond delay="indefinite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animBg="1"/>
      <p:bldP spid="10" grpId="0" animBg="1"/>
      <p:bldP spid="15" grpId="0" animBg="1"/>
      <p:bldP spid="16" grpId="0" animBg="1"/>
      <p:bldP spid="17" grpId="0" animBg="1"/>
      <p:bldP spid="18" grpId="0" animBg="1"/>
      <p:bldP spid="30" grpId="0" animBg="1"/>
      <p:bldP spid="31" grpId="0" animBg="1"/>
      <p:bldP spid="32" grpId="0" animBg="1"/>
      <p:bldP spid="33" grpId="0" animBg="1"/>
      <p:bldP spid="34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dirty="0">
                <a:solidFill>
                  <a:prstClr val="black"/>
                </a:solidFill>
              </a:rPr>
              <a:t>Understand the consequences of an incorrect </a:t>
            </a:r>
            <a:r>
              <a:rPr lang="en-GB" dirty="0" err="1">
                <a:solidFill>
                  <a:prstClr val="black"/>
                </a:solidFill>
              </a:rPr>
              <a:t>penA</a:t>
            </a:r>
            <a:r>
              <a:rPr lang="en-GB" dirty="0">
                <a:solidFill>
                  <a:prstClr val="black"/>
                </a:solidFill>
              </a:rPr>
              <a:t> record</a:t>
            </a:r>
            <a:endParaRPr lang="en-GB" sz="18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76400"/>
            <a:ext cx="8229600" cy="4800600"/>
          </a:xfrm>
        </p:spPr>
        <p:txBody>
          <a:bodyPr>
            <a:normAutofit fontScale="70000" lnSpcReduction="20000"/>
          </a:bodyPr>
          <a:lstStyle/>
          <a:p>
            <a:pPr lvl="0"/>
            <a:r>
              <a:rPr lang="en-GB" sz="4100" dirty="0">
                <a:solidFill>
                  <a:prstClr val="black"/>
                </a:solidFill>
              </a:rPr>
              <a:t>15% of hospitalised patients have a penicillin allergy record.</a:t>
            </a:r>
          </a:p>
          <a:p>
            <a:pPr lvl="0"/>
            <a:r>
              <a:rPr lang="en-GB" sz="4100" dirty="0">
                <a:solidFill>
                  <a:prstClr val="black"/>
                </a:solidFill>
              </a:rPr>
              <a:t>Of these, &gt;95% can tolerate penicillin after formal allergy testing. </a:t>
            </a:r>
          </a:p>
          <a:p>
            <a:pPr lvl="0"/>
            <a:r>
              <a:rPr lang="en-GB" sz="4100" dirty="0">
                <a:solidFill>
                  <a:prstClr val="black"/>
                </a:solidFill>
              </a:rPr>
              <a:t>Penicillin allergy labels change the antibiotic management of infectious diseases.</a:t>
            </a:r>
          </a:p>
          <a:p>
            <a:pPr lvl="0"/>
            <a:r>
              <a:rPr lang="en-GB" sz="4100" dirty="0" err="1">
                <a:solidFill>
                  <a:prstClr val="black"/>
                </a:solidFill>
              </a:rPr>
              <a:t>PenA</a:t>
            </a:r>
            <a:r>
              <a:rPr lang="en-GB" sz="4100" dirty="0">
                <a:solidFill>
                  <a:prstClr val="black"/>
                </a:solidFill>
              </a:rPr>
              <a:t> records are </a:t>
            </a:r>
            <a:r>
              <a:rPr lang="en-GB" sz="4100">
                <a:solidFill>
                  <a:prstClr val="black"/>
                </a:solidFill>
              </a:rPr>
              <a:t>detrimental to </a:t>
            </a:r>
            <a:r>
              <a:rPr lang="en-GB" sz="4100" dirty="0">
                <a:solidFill>
                  <a:prstClr val="black"/>
                </a:solidFill>
              </a:rPr>
              <a:t>patients (mortality), healthcare systems (increased antibiotic costs) and wider society (AMR).</a:t>
            </a:r>
          </a:p>
          <a:p>
            <a:pPr lvl="0"/>
            <a:r>
              <a:rPr lang="en-GB" sz="4100" dirty="0">
                <a:solidFill>
                  <a:prstClr val="black"/>
                </a:solidFill>
              </a:rPr>
              <a:t>Taking an accurate penicillin allergy history can improve management of infectious diseases and reduce antibiotic associated risks</a:t>
            </a:r>
          </a:p>
          <a:p>
            <a:pPr marL="0" indent="0">
              <a:spcAft>
                <a:spcPts val="0"/>
              </a:spcAft>
              <a:buNone/>
            </a:pPr>
            <a:endParaRPr lang="en-GB" sz="3600" dirty="0">
              <a:latin typeface="Times New Roman"/>
              <a:ea typeface="Calibri"/>
            </a:endParaRPr>
          </a:p>
          <a:p>
            <a:pPr marL="0" indent="0">
              <a:spcAft>
                <a:spcPts val="0"/>
              </a:spcAft>
              <a:buNone/>
            </a:pPr>
            <a:endParaRPr lang="en-GB" sz="3600" dirty="0">
              <a:latin typeface="Times New Roman"/>
              <a:ea typeface="Calibri"/>
            </a:endParaRPr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D2FCD3-F423-11FB-5AB7-E428F5735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</a:t>
            </a:fld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4456210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6581"/>
    </mc:Choice>
    <mc:Fallback xmlns="">
      <p:transition spd="slow" advTm="26581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BEC5AE-86CC-E9B2-795A-32033741A2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0CFB88-AD59-85EC-C826-40DD16B50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AAF3AD-F261-E023-63C7-CCDD496044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121275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38C899-3E39-4198-CD0D-D346D7A49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0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359189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formation to patients &amp; other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GB" dirty="0"/>
              <a:t>Patients that tolerate the penicillin challenge have a 2-3% chance of mild delayed skin eruption on future exposure to penicillin (baseline rate). None have been serious.</a:t>
            </a:r>
          </a:p>
          <a:p>
            <a:r>
              <a:rPr lang="en-GB" dirty="0"/>
              <a:t>Patients can become re-sensitised to penicillin in future (rare, comparable to baseline risk).</a:t>
            </a:r>
          </a:p>
          <a:p>
            <a:r>
              <a:rPr lang="en-GB" dirty="0"/>
              <a:t>Anaphylaxis is rare;</a:t>
            </a:r>
          </a:p>
          <a:p>
            <a:pPr marL="0" indent="0">
              <a:buNone/>
            </a:pPr>
            <a:r>
              <a:rPr lang="en-GB" sz="2600" dirty="0"/>
              <a:t>  - 0.001% for parenteral exposures (1 in 95,298 exposures)</a:t>
            </a:r>
          </a:p>
          <a:p>
            <a:pPr marL="0" indent="0">
              <a:buNone/>
            </a:pPr>
            <a:r>
              <a:rPr lang="en-GB" sz="2600" dirty="0"/>
              <a:t>  - 0.0005% for oral exposures (1 in 207,191 exposures)</a:t>
            </a:r>
          </a:p>
          <a:p>
            <a:endParaRPr lang="en-GB" dirty="0"/>
          </a:p>
          <a:p>
            <a:pPr marL="0" indent="0">
              <a:buNone/>
            </a:pP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22E3CC-7915-DEE6-5634-6ECB29647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60266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2CBF59-F7B5-39FF-9EA9-52FDE068EF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CD5C0-6FF0-76CC-5DA4-4107A09A2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57D7C7-58B7-3246-0604-E8C4C599FF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83162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C3CB61-EE74-6336-6A38-D409BA771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5642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3D1BAD-9099-C7A4-0DD1-01903E696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Governance Framework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7BA5DB-4FC5-1EF9-E105-BCFD6CA53C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De-labelling in line with </a:t>
            </a:r>
            <a:r>
              <a:rPr lang="en-GB" u="sng" dirty="0"/>
              <a:t>RCHT PADL guidelines </a:t>
            </a:r>
            <a:r>
              <a:rPr lang="en-GB" dirty="0"/>
              <a:t>is important for patient safety and to ensure you are working within hospital agreed parameters.</a:t>
            </a:r>
          </a:p>
          <a:p>
            <a:r>
              <a:rPr lang="en-GB" dirty="0"/>
              <a:t>The </a:t>
            </a:r>
            <a:r>
              <a:rPr kumimoji="0" lang="en-GB" sz="3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CHT PADL guidelines </a:t>
            </a:r>
            <a:r>
              <a:rPr kumimoji="0" lang="en-GB" sz="3200" b="0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ave been signed off by the Medicines Practice Committee and working within these guidelines ensures your actions are supported by the organisation. 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3FF75A-5023-D2EC-775E-15FF2A579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43476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3D1BAD-9099-C7A4-0DD1-01903E696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Governance Framework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7BA5DB-4FC5-1EF9-E105-BCFD6CA53C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dirty="0"/>
              <a:t>Decision support tool has been validated as safe and effective for identifying low risk patients for de-label</a:t>
            </a:r>
            <a:r>
              <a:rPr kumimoji="0" lang="en-GB" sz="3200" b="0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.</a:t>
            </a:r>
          </a:p>
          <a:p>
            <a:r>
              <a:rPr lang="en-GB" dirty="0">
                <a:solidFill>
                  <a:prstClr val="black"/>
                </a:solidFill>
                <a:latin typeface="Calibri"/>
              </a:rPr>
              <a:t>ID physician, antimicrobial pharmacists, medical microbiology and ward pharmacists can support PADL and offer advice, where needed.</a:t>
            </a:r>
          </a:p>
          <a:p>
            <a:r>
              <a:rPr kumimoji="0" lang="en-GB" sz="3200" b="0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onsultant Antimicrobial Pharmacist is clinical lead for PADL and ID consultant medical lead for PADL: do feedback concerns to these two members of staff.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6467AB-A3BB-4D2F-BBAF-86EAF046E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05614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o conclud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GB" dirty="0" err="1"/>
              <a:t>PenA</a:t>
            </a:r>
            <a:r>
              <a:rPr lang="en-GB" dirty="0"/>
              <a:t> records create inequality of care for those requiring antibiotics; often receiving second line care.</a:t>
            </a:r>
          </a:p>
          <a:p>
            <a:r>
              <a:rPr lang="en-GB" dirty="0"/>
              <a:t>PADL is therefore a medication safety &amp; AMS priority.  </a:t>
            </a:r>
          </a:p>
          <a:p>
            <a:r>
              <a:rPr lang="en-GB" dirty="0"/>
              <a:t>Non-allergy assessment and de-label by DOC is a safe and effective antibiotic stewardship intervention.</a:t>
            </a:r>
          </a:p>
          <a:p>
            <a:r>
              <a:rPr lang="en-GB" dirty="0"/>
              <a:t>The benefits to antibiotic stewardship are well described; with potential for improved patient and health-system outcomes. </a:t>
            </a:r>
          </a:p>
          <a:p>
            <a:r>
              <a:rPr lang="en-GB" dirty="0"/>
              <a:t>We have described the risk stratification and de-label process.</a:t>
            </a:r>
          </a:p>
          <a:p>
            <a:r>
              <a:rPr lang="en-GB" dirty="0"/>
              <a:t>We have described the components of the patient pathway that will ensure the process is safe and effectiv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2F11A8-C001-46FD-2380-5AE8CDA96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5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487086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FF018A-22E1-9E1D-E8B6-FD7245B038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148473-18F2-10FF-F017-A82164888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C522FF-FC5D-126A-9E10-47FE2F2923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121275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3FCEA8-78D9-4632-7B1A-1BBD520F2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6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44143103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14DD2-4164-8B93-7624-80A6C599BC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urther resour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42C059-2EB8-E6A6-BF83-611AB2A4FF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GB" dirty="0"/>
              <a:t>Understanding Penicillin Allergy Assessment and </a:t>
            </a:r>
            <a:r>
              <a:rPr lang="en-GB" dirty="0" err="1"/>
              <a:t>Delabelling</a:t>
            </a:r>
            <a:r>
              <a:rPr lang="en-GB" dirty="0"/>
              <a:t> (BSAC) </a:t>
            </a:r>
            <a:r>
              <a:rPr lang="en-GB" dirty="0">
                <a:hlinkClick r:id="rId2"/>
              </a:rPr>
              <a:t>https://www.futurelearn.com/courses/understanding-penicillin-allergy-assessment-and-delabelling</a:t>
            </a:r>
            <a:endParaRPr lang="en-GB" dirty="0"/>
          </a:p>
          <a:p>
            <a:r>
              <a:rPr lang="en-GB" dirty="0"/>
              <a:t>Kimberly G Blumenthal, Jonny G Peter, Jason A </a:t>
            </a:r>
            <a:r>
              <a:rPr lang="en-GB" dirty="0" err="1"/>
              <a:t>Trubiano</a:t>
            </a:r>
            <a:r>
              <a:rPr lang="en-GB" dirty="0"/>
              <a:t>, Elizabeth J Phillips. Antibiotic allergy. Lancet 2018. </a:t>
            </a:r>
            <a:r>
              <a:rPr lang="en-GB" dirty="0">
                <a:hlinkClick r:id="rId3"/>
              </a:rPr>
              <a:t>http://dx.doi.org/10.1016/S0140-6736(18)32218-9</a:t>
            </a:r>
            <a:endParaRPr lang="en-GB" dirty="0"/>
          </a:p>
          <a:p>
            <a:r>
              <a:rPr lang="en-GB" dirty="0"/>
              <a:t>Erica S. Shenoy, Eric Macy, Theresa Rowe, Kimberly G. Blumenthal, Evaluation and Management of Penicillin Allergy A Review. JAMA 2019. doi:10.1001/jama.2018.19283</a:t>
            </a:r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C071DA-89AD-9E47-2235-D706DBF80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490642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mpetenci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029200"/>
          </a:xfrm>
        </p:spPr>
        <p:txBody>
          <a:bodyPr>
            <a:normAutofit fontScale="77500" lnSpcReduction="20000"/>
          </a:bodyPr>
          <a:lstStyle/>
          <a:p>
            <a:r>
              <a:rPr lang="en-GB" dirty="0"/>
              <a:t>Understand the consequences of an incorrect </a:t>
            </a:r>
            <a:r>
              <a:rPr lang="en-GB" dirty="0" err="1"/>
              <a:t>penA</a:t>
            </a:r>
            <a:r>
              <a:rPr lang="en-GB" dirty="0"/>
              <a:t> record.</a:t>
            </a:r>
          </a:p>
          <a:p>
            <a:r>
              <a:rPr lang="en-GB" dirty="0"/>
              <a:t>Understand drug allergy phenotypes and to differentiate these from drug intolerances.</a:t>
            </a:r>
          </a:p>
          <a:p>
            <a:r>
              <a:rPr lang="en-GB" dirty="0"/>
              <a:t>Know which allergy phenotypes are eligible for de-label.</a:t>
            </a:r>
          </a:p>
          <a:p>
            <a:r>
              <a:rPr lang="en-GB" dirty="0"/>
              <a:t>Know which allergy phenotypes are not eligible for de-label.</a:t>
            </a:r>
          </a:p>
          <a:p>
            <a:r>
              <a:rPr lang="en-GB" dirty="0"/>
              <a:t>Understand the requirements of a </a:t>
            </a:r>
            <a:r>
              <a:rPr lang="en-GB" dirty="0" err="1"/>
              <a:t>penA</a:t>
            </a:r>
            <a:r>
              <a:rPr lang="en-GB" dirty="0"/>
              <a:t> focused history.</a:t>
            </a:r>
          </a:p>
          <a:p>
            <a:r>
              <a:rPr lang="en-GB" dirty="0"/>
              <a:t>Know how to risk assess </a:t>
            </a:r>
            <a:r>
              <a:rPr lang="en-GB" dirty="0" err="1"/>
              <a:t>penA</a:t>
            </a:r>
            <a:r>
              <a:rPr lang="en-GB" dirty="0"/>
              <a:t> histories using a decision support tool.</a:t>
            </a:r>
          </a:p>
          <a:p>
            <a:r>
              <a:rPr lang="en-GB" dirty="0"/>
              <a:t>Know the de-label methods and processes.</a:t>
            </a:r>
          </a:p>
          <a:p>
            <a:r>
              <a:rPr lang="en-GB" dirty="0"/>
              <a:t>Understand the risk of future reactions in low-risk patients.</a:t>
            </a:r>
          </a:p>
          <a:p>
            <a:r>
              <a:rPr lang="en-GB" dirty="0"/>
              <a:t>Understand that PADL is done within a governance framework.</a:t>
            </a:r>
          </a:p>
          <a:p>
            <a:pPr marL="0" indent="0">
              <a:buNone/>
            </a:pP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EAFC5F-087A-2E06-1072-4230AA21B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1579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9C749EA-927B-DB89-C918-50F83CD336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08421-90F3-B5C5-DEC3-2823CFE327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he cont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968893-A133-20AF-CEED-80C88E9757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83162"/>
          </a:xfrm>
        </p:spPr>
        <p:txBody>
          <a:bodyPr>
            <a:normAutofit lnSpcReduction="10000"/>
          </a:bodyPr>
          <a:lstStyle/>
          <a:p>
            <a:r>
              <a:rPr lang="en-GB" dirty="0"/>
              <a:t>Background; consequences of </a:t>
            </a:r>
            <a:r>
              <a:rPr lang="en-GB" dirty="0" err="1"/>
              <a:t>penA</a:t>
            </a:r>
            <a:r>
              <a:rPr lang="en-GB" dirty="0"/>
              <a:t> records</a:t>
            </a:r>
          </a:p>
          <a:p>
            <a:r>
              <a:rPr lang="en-GB" dirty="0"/>
              <a:t>Drug allergy phenotypes</a:t>
            </a:r>
          </a:p>
          <a:p>
            <a:r>
              <a:rPr lang="en-GB" dirty="0"/>
              <a:t>Tak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Risk assessing a </a:t>
            </a:r>
            <a:r>
              <a:rPr lang="en-GB" dirty="0" err="1"/>
              <a:t>penA</a:t>
            </a:r>
            <a:r>
              <a:rPr lang="en-GB" dirty="0"/>
              <a:t> history</a:t>
            </a:r>
          </a:p>
          <a:p>
            <a:r>
              <a:rPr lang="en-GB" dirty="0"/>
              <a:t>Determining de-label method</a:t>
            </a:r>
          </a:p>
          <a:p>
            <a:r>
              <a:rPr lang="en-GB" dirty="0"/>
              <a:t>Documenting a </a:t>
            </a:r>
            <a:r>
              <a:rPr lang="en-GB" dirty="0" err="1"/>
              <a:t>penA</a:t>
            </a:r>
            <a:r>
              <a:rPr lang="en-GB" dirty="0"/>
              <a:t> focused history</a:t>
            </a:r>
          </a:p>
          <a:p>
            <a:r>
              <a:rPr lang="en-GB" dirty="0"/>
              <a:t>The de-label process </a:t>
            </a:r>
          </a:p>
          <a:p>
            <a:r>
              <a:rPr lang="en-GB" dirty="0"/>
              <a:t>Patient counselling</a:t>
            </a:r>
          </a:p>
          <a:p>
            <a:r>
              <a:rPr lang="en-GB" dirty="0"/>
              <a:t>Governance framewor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C2CB0E-1C14-A019-7D5C-2F8B30100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F15528-21DE-4FAA-801E-634DDDAF4B2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170622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953"/>
    </mc:Choice>
    <mc:Fallback xmlns="">
      <p:transition spd="slow" advTm="953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 tmFilter="0, 0; .2, .5; .8, .5; 1, 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7" dur="250" autoRev="1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96CB35-CBCA-601D-57D5-5795DC47B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1143000"/>
          </a:xfrm>
        </p:spPr>
        <p:txBody>
          <a:bodyPr>
            <a:normAutofit fontScale="90000"/>
          </a:bodyPr>
          <a:lstStyle/>
          <a:p>
            <a:pPr marL="0" marR="0" lvl="0" indent="0" defTabSz="914400" rtl="0" eaLnBrk="1" fontAlgn="auto" latinLnBrk="0" hangingPunct="1">
              <a:lnSpc>
                <a:spcPts val="3600"/>
              </a:lnSpc>
              <a:spcBef>
                <a:spcPts val="900"/>
              </a:spcBef>
              <a:spcAft>
                <a:spcPts val="900"/>
              </a:spcAft>
              <a:tabLst/>
              <a:defRPr/>
            </a:pPr>
            <a:r>
              <a:rPr lang="en-GB" sz="4000" b="1" dirty="0">
                <a:solidFill>
                  <a:prstClr val="black"/>
                </a:solidFill>
              </a:rPr>
              <a:t>Drug allergy: diagnosis and management</a:t>
            </a:r>
            <a:br>
              <a:rPr lang="en-GB" sz="4000" b="1" dirty="0">
                <a:solidFill>
                  <a:prstClr val="black"/>
                </a:solidFill>
              </a:rPr>
            </a:br>
            <a:r>
              <a:rPr lang="en-GB" sz="4000" b="1" dirty="0">
                <a:solidFill>
                  <a:prstClr val="black"/>
                </a:solidFill>
              </a:rPr>
              <a:t>NICE guidelines [CG183] Published date: </a:t>
            </a:r>
            <a:r>
              <a:rPr lang="en-GB" sz="2700" b="1" dirty="0">
                <a:solidFill>
                  <a:prstClr val="black"/>
                </a:solidFill>
              </a:rPr>
              <a:t>September 2014 </a:t>
            </a:r>
            <a:br>
              <a:rPr lang="en-GB" sz="2700" dirty="0">
                <a:solidFill>
                  <a:prstClr val="black"/>
                </a:solidFill>
              </a:rPr>
            </a:br>
            <a:r>
              <a:rPr lang="en-GB" sz="2700" dirty="0">
                <a:solidFill>
                  <a:prstClr val="black"/>
                </a:solidFill>
              </a:rPr>
              <a:t>https://www.nice.org.uk/guidance/CG183/chapter/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D622A1-4200-FB98-00C5-4BC9C4F668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2209800"/>
            <a:ext cx="8229600" cy="3916363"/>
          </a:xfrm>
        </p:spPr>
        <p:txBody>
          <a:bodyPr/>
          <a:lstStyle/>
          <a:p>
            <a:endParaRPr lang="en-GB" dirty="0"/>
          </a:p>
          <a:p>
            <a:r>
              <a:rPr lang="en-GB" dirty="0"/>
              <a:t>Immediate, rapidly evolving reactions (</a:t>
            </a:r>
            <a:r>
              <a:rPr lang="en-GB" dirty="0" err="1"/>
              <a:t>IgE</a:t>
            </a:r>
            <a:r>
              <a:rPr lang="en-GB" dirty="0"/>
              <a:t>-medicated)</a:t>
            </a:r>
          </a:p>
          <a:p>
            <a:r>
              <a:rPr lang="en-GB" dirty="0"/>
              <a:t>Non immediate reactions with systemic involvement (cell mediated)</a:t>
            </a:r>
          </a:p>
          <a:p>
            <a:r>
              <a:rPr lang="en-GB" dirty="0"/>
              <a:t>Non immediate reactions without systemic involvement (cell mediated)</a:t>
            </a:r>
          </a:p>
          <a:p>
            <a:endParaRPr lang="en-GB" dirty="0"/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7D2BCB-5C6B-A6A9-B84F-74C281982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0254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CA93C6DB-D447-4FFA-86B7-340C4E081B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1184" y="360455"/>
            <a:ext cx="7634616" cy="1011146"/>
          </a:xfrm>
        </p:spPr>
        <p:txBody>
          <a:bodyPr>
            <a:normAutofit/>
          </a:bodyPr>
          <a:lstStyle/>
          <a:p>
            <a:r>
              <a:rPr lang="en-GB" sz="2800" b="1" dirty="0">
                <a:latin typeface="Arial" panose="020B0604020202020204" pitchFamily="34" charset="0"/>
                <a:cs typeface="Arial" panose="020B0604020202020204" pitchFamily="34" charset="0"/>
              </a:rPr>
              <a:t>Immediate rapidly evolving reactions</a:t>
            </a:r>
            <a:br>
              <a:rPr lang="en-GB" sz="28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(also called </a:t>
            </a:r>
            <a:r>
              <a:rPr lang="en-GB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Gell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&amp; Coombs type 1) </a:t>
            </a:r>
            <a:endParaRPr lang="en-GB" sz="2000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04327D09-7895-4C36-9496-D5F61A8E87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08563" y="2057400"/>
            <a:ext cx="4163437" cy="3263504"/>
          </a:xfrm>
        </p:spPr>
        <p:txBody>
          <a:bodyPr>
            <a:normAutofit/>
          </a:bodyPr>
          <a:lstStyle/>
          <a:p>
            <a:r>
              <a:rPr lang="en-GB" sz="2000" u="sng" dirty="0">
                <a:latin typeface="Arial" panose="020B0604020202020204" pitchFamily="34" charset="0"/>
                <a:cs typeface="Arial" panose="020B0604020202020204" pitchFamily="34" charset="0"/>
              </a:rPr>
              <a:t>Anaphylaxis</a:t>
            </a:r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 – a severe multi-system reaction characterised by: erythema, urticaria or angioedema and hypotension and/or bronchospasm</a:t>
            </a:r>
          </a:p>
          <a:p>
            <a:r>
              <a:rPr lang="en-GB" sz="2000" u="sng" dirty="0">
                <a:latin typeface="Arial" panose="020B0604020202020204" pitchFamily="34" charset="0"/>
                <a:cs typeface="Arial" panose="020B0604020202020204" pitchFamily="34" charset="0"/>
              </a:rPr>
              <a:t>Urticaria</a:t>
            </a:r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GB" sz="2000" u="sng" dirty="0">
                <a:latin typeface="Arial" panose="020B0604020202020204" pitchFamily="34" charset="0"/>
                <a:cs typeface="Arial" panose="020B0604020202020204" pitchFamily="34" charset="0"/>
              </a:rPr>
              <a:t>angioedema</a:t>
            </a:r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 without systemic features</a:t>
            </a:r>
          </a:p>
          <a:p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Onset usually </a:t>
            </a:r>
            <a:r>
              <a:rPr lang="en-GB" sz="2000" u="sng" dirty="0">
                <a:latin typeface="Arial" panose="020B0604020202020204" pitchFamily="34" charset="0"/>
                <a:cs typeface="Arial" panose="020B0604020202020204" pitchFamily="34" charset="0"/>
              </a:rPr>
              <a:t>less than 1 hour </a:t>
            </a:r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after drug exposure</a:t>
            </a:r>
          </a:p>
        </p:txBody>
      </p:sp>
      <p:pic>
        <p:nvPicPr>
          <p:cNvPr id="1028" name="Picture 4" descr="Acute urticaria">
            <a:extLst>
              <a:ext uri="{FF2B5EF4-FFF2-40B4-BE49-F238E27FC236}">
                <a16:creationId xmlns:a16="http://schemas.microsoft.com/office/drawing/2014/main" id="{A800A232-7F7B-43D1-967D-52F19C8D6B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3200" y="3789636"/>
            <a:ext cx="2279011" cy="17225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E50160C-CBD7-49D5-96A9-38E945CAB2F6}"/>
              </a:ext>
            </a:extLst>
          </p:cNvPr>
          <p:cNvSpPr txBox="1"/>
          <p:nvPr/>
        </p:nvSpPr>
        <p:spPr>
          <a:xfrm>
            <a:off x="7025541" y="5574347"/>
            <a:ext cx="2449359" cy="2077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/>
            <a:r>
              <a:rPr lang="en-GB" sz="750" dirty="0">
                <a:solidFill>
                  <a:prstClr val="black"/>
                </a:solidFill>
                <a:latin typeface="Calibri" panose="020F0502020204030204"/>
              </a:rPr>
              <a:t>https://dermnetnz.org</a:t>
            </a:r>
          </a:p>
        </p:txBody>
      </p:sp>
      <p:pic>
        <p:nvPicPr>
          <p:cNvPr id="1030" name="Picture 6" descr="Angioedema">
            <a:extLst>
              <a:ext uri="{FF2B5EF4-FFF2-40B4-BE49-F238E27FC236}">
                <a16:creationId xmlns:a16="http://schemas.microsoft.com/office/drawing/2014/main" id="{48715942-DBB1-45A7-83D6-84EABD08FB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3627" y="1750573"/>
            <a:ext cx="2445708" cy="1848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Angioedema">
            <a:extLst>
              <a:ext uri="{FF2B5EF4-FFF2-40B4-BE49-F238E27FC236}">
                <a16:creationId xmlns:a16="http://schemas.microsoft.com/office/drawing/2014/main" id="{4C4D778B-16A9-4005-9070-0F88B29C62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7108" y="1750572"/>
            <a:ext cx="2445709" cy="18485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BF19FA5-1EA2-F158-257B-77BB40B97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6</a:t>
            </a:fld>
            <a:endParaRPr lang="en-US"/>
          </a:p>
        </p:txBody>
      </p:sp>
      <p:pic>
        <p:nvPicPr>
          <p:cNvPr id="6" name="Picture 5" descr="A close up of a person's knee&#10;&#10;Description automatically generated">
            <a:extLst>
              <a:ext uri="{FF2B5EF4-FFF2-40B4-BE49-F238E27FC236}">
                <a16:creationId xmlns:a16="http://schemas.microsoft.com/office/drawing/2014/main" id="{B3ABBD81-7DF0-8E8F-7686-A82D836135C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3825" y="5000092"/>
            <a:ext cx="2619375" cy="1743075"/>
          </a:xfrm>
          <a:prstGeom prst="rect">
            <a:avLst/>
          </a:prstGeom>
        </p:spPr>
      </p:pic>
      <p:pic>
        <p:nvPicPr>
          <p:cNvPr id="8" name="Picture 7" descr="A close-up of a skin&#10;&#10;Description automatically generated">
            <a:extLst>
              <a:ext uri="{FF2B5EF4-FFF2-40B4-BE49-F238E27FC236}">
                <a16:creationId xmlns:a16="http://schemas.microsoft.com/office/drawing/2014/main" id="{627945DA-7EFF-0B39-985F-00C43C3BDF3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779" y="5021162"/>
            <a:ext cx="2948380" cy="16510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8831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85843-C12D-4BB9-9812-E26093D49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831" y="251015"/>
            <a:ext cx="8533769" cy="994172"/>
          </a:xfrm>
        </p:spPr>
        <p:txBody>
          <a:bodyPr>
            <a:normAutofit/>
          </a:bodyPr>
          <a:lstStyle/>
          <a:p>
            <a:r>
              <a:rPr lang="en-GB" sz="2600" b="1" dirty="0">
                <a:latin typeface="Arial" panose="020B0604020202020204" pitchFamily="34" charset="0"/>
                <a:cs typeface="Arial" panose="020B0604020202020204" pitchFamily="34" charset="0"/>
              </a:rPr>
              <a:t>Non-immediate reactions with systemic involvement</a:t>
            </a:r>
            <a:br>
              <a:rPr lang="en-GB" sz="26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 (also called </a:t>
            </a:r>
            <a:r>
              <a:rPr lang="en-GB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Gell</a:t>
            </a:r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 &amp; Coombs type 4) </a:t>
            </a:r>
            <a:endParaRPr lang="en-GB" sz="2400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3C681C-D443-482D-A135-4B626ACD67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9820" y="1548094"/>
            <a:ext cx="4045021" cy="3263504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ute generalised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exanthematous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 pustulosis (AGEP) characterised by:</a:t>
            </a:r>
          </a:p>
          <a:p>
            <a:pPr marL="0" indent="0">
              <a:buNone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widespread pustules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ever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eutrophilia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Onset usually 3–5 days after first drug exposure</a:t>
            </a:r>
          </a:p>
        </p:txBody>
      </p:sp>
      <p:pic>
        <p:nvPicPr>
          <p:cNvPr id="5122" name="Picture 2" descr="Acute generalised exanthematous pustulosis">
            <a:extLst>
              <a:ext uri="{FF2B5EF4-FFF2-40B4-BE49-F238E27FC236}">
                <a16:creationId xmlns:a16="http://schemas.microsoft.com/office/drawing/2014/main" id="{EDEAA07A-B21C-493E-83D3-AB498265209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0" r="21709" b="-1"/>
          <a:stretch/>
        </p:blipFill>
        <p:spPr bwMode="auto">
          <a:xfrm>
            <a:off x="4485914" y="1176203"/>
            <a:ext cx="2996334" cy="2996334"/>
          </a:xfrm>
          <a:custGeom>
            <a:avLst/>
            <a:gdLst/>
            <a:ahLst/>
            <a:cxnLst/>
            <a:rect l="l" t="t" r="r" b="b"/>
            <a:pathLst>
              <a:path w="2663168" h="2663168">
                <a:moveTo>
                  <a:pt x="1331584" y="0"/>
                </a:moveTo>
                <a:cubicBezTo>
                  <a:pt x="2066998" y="0"/>
                  <a:pt x="2663168" y="596170"/>
                  <a:pt x="2663168" y="1331584"/>
                </a:cubicBezTo>
                <a:cubicBezTo>
                  <a:pt x="2663168" y="2066998"/>
                  <a:pt x="2066998" y="2663168"/>
                  <a:pt x="1331584" y="2663168"/>
                </a:cubicBezTo>
                <a:cubicBezTo>
                  <a:pt x="596170" y="2663168"/>
                  <a:pt x="0" y="2066998"/>
                  <a:pt x="0" y="1331584"/>
                </a:cubicBezTo>
                <a:cubicBezTo>
                  <a:pt x="0" y="596170"/>
                  <a:pt x="596170" y="0"/>
                  <a:pt x="1331584" y="0"/>
                </a:cubicBez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6384CEB-C93B-4795-B2A5-0FC9E164B945}"/>
              </a:ext>
            </a:extLst>
          </p:cNvPr>
          <p:cNvSpPr txBox="1"/>
          <p:nvPr/>
        </p:nvSpPr>
        <p:spPr>
          <a:xfrm>
            <a:off x="6597612" y="3872455"/>
            <a:ext cx="1769272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/>
            <a:r>
              <a:rPr lang="en-GB" sz="1350" dirty="0">
                <a:solidFill>
                  <a:prstClr val="black"/>
                </a:solidFill>
                <a:latin typeface="Calibri" panose="020F0502020204030204"/>
              </a:rPr>
              <a:t>https://dermnetnz.or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10FBFB-9C59-8BB8-1E97-C6070495E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7</a:t>
            </a:fld>
            <a:endParaRPr lang="en-US"/>
          </a:p>
        </p:txBody>
      </p:sp>
      <p:pic>
        <p:nvPicPr>
          <p:cNvPr id="6" name="Picture 5" descr="A person's skin with small bumps&#10;&#10;Description automatically generated">
            <a:extLst>
              <a:ext uri="{FF2B5EF4-FFF2-40B4-BE49-F238E27FC236}">
                <a16:creationId xmlns:a16="http://schemas.microsoft.com/office/drawing/2014/main" id="{7C529113-1EDE-9038-0E2F-E05349E4B6C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000" y="4114909"/>
            <a:ext cx="2133600" cy="2606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56476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CC473-EACD-49E7-B86A-0103F9EB24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6700" y="492673"/>
            <a:ext cx="8610599" cy="474413"/>
          </a:xfrm>
        </p:spPr>
        <p:txBody>
          <a:bodyPr anchor="b">
            <a:normAutofit fontScale="90000"/>
          </a:bodyPr>
          <a:lstStyle/>
          <a:p>
            <a:r>
              <a:rPr lang="en-GB" sz="3075" b="1" dirty="0"/>
              <a:t>Non-immediate reactions with systemic involvement</a:t>
            </a:r>
            <a:br>
              <a:rPr lang="en-GB" sz="3075" b="1" dirty="0"/>
            </a:br>
            <a:r>
              <a:rPr lang="en-GB" sz="2700" b="1" dirty="0"/>
              <a:t> (also called </a:t>
            </a:r>
            <a:r>
              <a:rPr lang="en-GB" sz="2700" b="1" dirty="0" err="1"/>
              <a:t>Gell</a:t>
            </a:r>
            <a:r>
              <a:rPr lang="en-GB" sz="2700" b="1" dirty="0"/>
              <a:t> &amp; Coombs type 4)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4DF1EE-4EEB-4909-BADC-F779C38191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06777" y="1332885"/>
            <a:ext cx="4939867" cy="2839064"/>
          </a:xfrm>
        </p:spPr>
        <p:txBody>
          <a:bodyPr>
            <a:noAutofit/>
          </a:bodyPr>
          <a:lstStyle/>
          <a:p>
            <a:r>
              <a:rPr lang="en-GB" sz="2000" dirty="0"/>
              <a:t>Drug reaction with eosinophilia and systemic symptoms (DRESS) or drug hypersensitivity syndrome (DHS) characterised by:</a:t>
            </a:r>
          </a:p>
          <a:p>
            <a:r>
              <a:rPr lang="en-GB" sz="2000" dirty="0"/>
              <a:t>widespread red macules, papules or erythroderma with systematic involvement;</a:t>
            </a:r>
          </a:p>
          <a:p>
            <a:pPr lvl="1"/>
            <a:r>
              <a:rPr lang="en-GB" sz="2000" dirty="0"/>
              <a:t>fever</a:t>
            </a:r>
          </a:p>
          <a:p>
            <a:pPr lvl="1"/>
            <a:r>
              <a:rPr lang="en-GB" sz="2000" dirty="0"/>
              <a:t>lymphadenopathy</a:t>
            </a:r>
          </a:p>
          <a:p>
            <a:pPr lvl="1"/>
            <a:r>
              <a:rPr lang="en-GB" sz="2000" dirty="0"/>
              <a:t>liver dysfunction</a:t>
            </a:r>
          </a:p>
          <a:p>
            <a:pPr lvl="1"/>
            <a:r>
              <a:rPr lang="en-GB" sz="2000" dirty="0"/>
              <a:t>Eosinophilia</a:t>
            </a:r>
          </a:p>
          <a:p>
            <a:r>
              <a:rPr lang="en-GB" sz="2000" dirty="0"/>
              <a:t>Onset usually 2–6 weeks after first drug exposure or within 3 days of second exposure</a:t>
            </a:r>
          </a:p>
        </p:txBody>
      </p:sp>
      <p:pic>
        <p:nvPicPr>
          <p:cNvPr id="2056" name="Picture 8" descr="Drug eruption">
            <a:extLst>
              <a:ext uri="{FF2B5EF4-FFF2-40B4-BE49-F238E27FC236}">
                <a16:creationId xmlns:a16="http://schemas.microsoft.com/office/drawing/2014/main" id="{79AA2F18-DDFB-4A83-AD7D-C4F94705C5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24" y="1692723"/>
            <a:ext cx="2825851" cy="2119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Drug eruption">
            <a:extLst>
              <a:ext uri="{FF2B5EF4-FFF2-40B4-BE49-F238E27FC236}">
                <a16:creationId xmlns:a16="http://schemas.microsoft.com/office/drawing/2014/main" id="{B9A99924-AB80-433C-A593-E065C987E9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24" y="4105583"/>
            <a:ext cx="1957759" cy="26103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5830AD5-3F0A-4E2C-85A1-0A834A92FF99}"/>
              </a:ext>
            </a:extLst>
          </p:cNvPr>
          <p:cNvSpPr txBox="1"/>
          <p:nvPr/>
        </p:nvSpPr>
        <p:spPr>
          <a:xfrm>
            <a:off x="5562600" y="6352554"/>
            <a:ext cx="2291543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/>
            <a:r>
              <a:rPr lang="en-GB" sz="1350" dirty="0">
                <a:solidFill>
                  <a:prstClr val="black"/>
                </a:solidFill>
                <a:latin typeface="Calibri" panose="020F0502020204030204"/>
              </a:rPr>
              <a:t>https://dermnetnz.or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C3A08F-898F-928A-DA7D-1CCDA2C5C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3509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4B813-35B8-4E4C-A5BF-0425C92B6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9144000" cy="994172"/>
          </a:xfrm>
        </p:spPr>
        <p:txBody>
          <a:bodyPr>
            <a:normAutofit/>
          </a:bodyPr>
          <a:lstStyle/>
          <a:p>
            <a:r>
              <a:rPr lang="en-GB" sz="3200" b="1" dirty="0"/>
              <a:t>Non-immediate reactions with systemic involvement</a:t>
            </a:r>
            <a:br>
              <a:rPr lang="en-GB" sz="3200" b="1" dirty="0"/>
            </a:br>
            <a:r>
              <a:rPr lang="en-GB" sz="2700" b="1" dirty="0"/>
              <a:t>(also called </a:t>
            </a:r>
            <a:r>
              <a:rPr lang="en-GB" sz="2700" b="1" dirty="0" err="1"/>
              <a:t>Gell</a:t>
            </a:r>
            <a:r>
              <a:rPr lang="en-GB" sz="2700" b="1" dirty="0"/>
              <a:t> &amp; Coombs type 4) </a:t>
            </a:r>
            <a:endParaRPr lang="en-GB" sz="2700" b="1" dirty="0">
              <a:highlight>
                <a:srgbClr val="00FFFF"/>
              </a:highlight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68D0BA-0F24-4BB6-AF05-AD308696FA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5702" y="1676400"/>
            <a:ext cx="6076497" cy="4495800"/>
          </a:xfrm>
        </p:spPr>
        <p:txBody>
          <a:bodyPr>
            <a:noAutofit/>
          </a:bodyPr>
          <a:lstStyle/>
          <a:p>
            <a:r>
              <a:rPr lang="en-GB" sz="2000" dirty="0"/>
              <a:t>Toxic epidermal necrolysis or Stevens–Johnson syndrome characterised by:</a:t>
            </a:r>
          </a:p>
          <a:p>
            <a:pPr lvl="1"/>
            <a:r>
              <a:rPr lang="en-GB" sz="2000" dirty="0"/>
              <a:t>painful rash and fever (often early signs)</a:t>
            </a:r>
          </a:p>
          <a:p>
            <a:pPr lvl="1"/>
            <a:r>
              <a:rPr lang="en-GB" sz="2000" dirty="0"/>
              <a:t>mucosal or cutaneous erosions</a:t>
            </a:r>
          </a:p>
          <a:p>
            <a:pPr lvl="1"/>
            <a:r>
              <a:rPr lang="en-GB" sz="2000" dirty="0"/>
              <a:t>vesicles, blistering or epidermal detachment</a:t>
            </a:r>
          </a:p>
          <a:p>
            <a:pPr lvl="1"/>
            <a:r>
              <a:rPr lang="en-GB" sz="2000" dirty="0"/>
              <a:t>red purpuric macules or erythema multiforme</a:t>
            </a:r>
          </a:p>
          <a:p>
            <a:r>
              <a:rPr lang="en-GB" sz="2000" dirty="0"/>
              <a:t>Onset usually 7–14 days after first drug exposure or within 3 days of second exposure</a:t>
            </a:r>
          </a:p>
        </p:txBody>
      </p:sp>
      <p:pic>
        <p:nvPicPr>
          <p:cNvPr id="4098" name="Picture 2" descr="SJS-TEN">
            <a:extLst>
              <a:ext uri="{FF2B5EF4-FFF2-40B4-BE49-F238E27FC236}">
                <a16:creationId xmlns:a16="http://schemas.microsoft.com/office/drawing/2014/main" id="{15EC6083-384A-4968-A7CE-AE3ED14603A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27" r="15892"/>
          <a:stretch/>
        </p:blipFill>
        <p:spPr bwMode="auto">
          <a:xfrm>
            <a:off x="5821080" y="3092846"/>
            <a:ext cx="3263504" cy="3263504"/>
          </a:xfrm>
          <a:custGeom>
            <a:avLst/>
            <a:gdLst/>
            <a:ahLst/>
            <a:cxnLst/>
            <a:rect l="l" t="t" r="r" b="b"/>
            <a:pathLst>
              <a:path w="2663168" h="2663168">
                <a:moveTo>
                  <a:pt x="1331584" y="0"/>
                </a:moveTo>
                <a:cubicBezTo>
                  <a:pt x="2066998" y="0"/>
                  <a:pt x="2663168" y="596170"/>
                  <a:pt x="2663168" y="1331584"/>
                </a:cubicBezTo>
                <a:cubicBezTo>
                  <a:pt x="2663168" y="2066998"/>
                  <a:pt x="2066998" y="2663168"/>
                  <a:pt x="1331584" y="2663168"/>
                </a:cubicBezTo>
                <a:cubicBezTo>
                  <a:pt x="596170" y="2663168"/>
                  <a:pt x="0" y="2066998"/>
                  <a:pt x="0" y="1331584"/>
                </a:cubicBezTo>
                <a:cubicBezTo>
                  <a:pt x="0" y="596170"/>
                  <a:pt x="596170" y="0"/>
                  <a:pt x="1331584" y="0"/>
                </a:cubicBez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782E0EB-EAED-4A32-8AEF-CE3EA36AC225}"/>
              </a:ext>
            </a:extLst>
          </p:cNvPr>
          <p:cNvSpPr txBox="1"/>
          <p:nvPr/>
        </p:nvSpPr>
        <p:spPr>
          <a:xfrm>
            <a:off x="6477000" y="6356350"/>
            <a:ext cx="1774376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/>
            <a:r>
              <a:rPr lang="en-GB" sz="1350" dirty="0">
                <a:solidFill>
                  <a:prstClr val="black"/>
                </a:solidFill>
                <a:latin typeface="Calibri" panose="020F0502020204030204"/>
              </a:rPr>
              <a:t>https://dermnetnz.or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9B8B0B-0EF9-0CE5-18E1-05A5B3215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9</a:t>
            </a:fld>
            <a:endParaRPr lang="en-US"/>
          </a:p>
        </p:txBody>
      </p:sp>
      <p:pic>
        <p:nvPicPr>
          <p:cNvPr id="6" name="Picture 5" descr="A close-up of a person's neck&#10;&#10;Description automatically generated">
            <a:extLst>
              <a:ext uri="{FF2B5EF4-FFF2-40B4-BE49-F238E27FC236}">
                <a16:creationId xmlns:a16="http://schemas.microsoft.com/office/drawing/2014/main" id="{24F5EBE5-A2F2-3D76-3E19-0F2BB9446FB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20" y="4521200"/>
            <a:ext cx="3520680" cy="2342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681961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3|5.6|7.4|4.6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76</TotalTime>
  <Words>2268</Words>
  <Application>Microsoft Office PowerPoint</Application>
  <PresentationFormat>On-screen Show (4:3)</PresentationFormat>
  <Paragraphs>327</Paragraphs>
  <Slides>38</Slides>
  <Notes>1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8</vt:i4>
      </vt:variant>
    </vt:vector>
  </HeadingPairs>
  <TitlesOfParts>
    <vt:vector size="44" baseType="lpstr">
      <vt:lpstr>Arial</vt:lpstr>
      <vt:lpstr>Calibri</vt:lpstr>
      <vt:lpstr>Calibri Light</vt:lpstr>
      <vt:lpstr>Times New Roman</vt:lpstr>
      <vt:lpstr>Office Theme</vt:lpstr>
      <vt:lpstr>Presentation</vt:lpstr>
      <vt:lpstr>Penicillin allergy assessment and de-label competency-based training</vt:lpstr>
      <vt:lpstr>The content</vt:lpstr>
      <vt:lpstr>Understand the consequences of an incorrect penA record</vt:lpstr>
      <vt:lpstr>The content</vt:lpstr>
      <vt:lpstr>Drug allergy: diagnosis and management NICE guidelines [CG183] Published date: September 2014  https://www.nice.org.uk/guidance/CG183/chapter/1</vt:lpstr>
      <vt:lpstr>Immediate rapidly evolving reactions (also called Gell &amp; Coombs type 1) </vt:lpstr>
      <vt:lpstr>Non-immediate reactions with systemic involvement  (also called Gell &amp; Coombs type 4) </vt:lpstr>
      <vt:lpstr>Non-immediate reactions with systemic involvement  (also called Gell &amp; Coombs type 4) </vt:lpstr>
      <vt:lpstr>Non-immediate reactions with systemic involvement (also called Gell &amp; Coombs type 4) </vt:lpstr>
      <vt:lpstr>Non-immediate reactions with systemic involvement (also called Gell &amp; Coombs types 2 &amp; 3) </vt:lpstr>
      <vt:lpstr>Non-immediate reactions without systemic involvement (also called Gell &amp; Coombs type 4) </vt:lpstr>
      <vt:lpstr>The content</vt:lpstr>
      <vt:lpstr>PowerPoint Presentation</vt:lpstr>
      <vt:lpstr>The content</vt:lpstr>
      <vt:lpstr>Decision support tools</vt:lpstr>
      <vt:lpstr>PowerPoint Presentation</vt:lpstr>
      <vt:lpstr>The content</vt:lpstr>
      <vt:lpstr>Management</vt:lpstr>
      <vt:lpstr>Management</vt:lpstr>
      <vt:lpstr>Management</vt:lpstr>
      <vt:lpstr>Management</vt:lpstr>
      <vt:lpstr>Management</vt:lpstr>
      <vt:lpstr>The content</vt:lpstr>
      <vt:lpstr>Then document this in EPMA</vt:lpstr>
      <vt:lpstr>PowerPoint Presentation</vt:lpstr>
      <vt:lpstr>PowerPoint Presentation</vt:lpstr>
      <vt:lpstr>The content</vt:lpstr>
      <vt:lpstr>De-label methods DDL ‘Direct de-label’ or de-label on history alone</vt:lpstr>
      <vt:lpstr>De-label methods DOC ‘Direct oral challenge’</vt:lpstr>
      <vt:lpstr>The content</vt:lpstr>
      <vt:lpstr>Information to patients &amp; others</vt:lpstr>
      <vt:lpstr>The content</vt:lpstr>
      <vt:lpstr>Governance Framework</vt:lpstr>
      <vt:lpstr>Governance Framework</vt:lpstr>
      <vt:lpstr>To conclude</vt:lpstr>
      <vt:lpstr>The content</vt:lpstr>
      <vt:lpstr>Further resources</vt:lpstr>
      <vt:lpstr>Competenci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nicillin allergy assessment and de-lable</dc:title>
  <dc:creator>Neil Powell</dc:creator>
  <cp:lastModifiedBy>POWELL, Neil (ROYAL CORNWALL HOSPITALS NHS TRUST)</cp:lastModifiedBy>
  <cp:revision>134</cp:revision>
  <dcterms:created xsi:type="dcterms:W3CDTF">2006-08-16T00:00:00Z</dcterms:created>
  <dcterms:modified xsi:type="dcterms:W3CDTF">2025-12-29T10:50:41Z</dcterms:modified>
</cp:coreProperties>
</file>